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677" r:id="rId2"/>
    <p:sldId id="710" r:id="rId3"/>
    <p:sldId id="711" r:id="rId4"/>
    <p:sldId id="617" r:id="rId5"/>
    <p:sldId id="620" r:id="rId6"/>
    <p:sldId id="712" r:id="rId7"/>
    <p:sldId id="686" r:id="rId8"/>
    <p:sldId id="296" r:id="rId9"/>
    <p:sldId id="258" r:id="rId10"/>
    <p:sldId id="259" r:id="rId11"/>
    <p:sldId id="261" r:id="rId12"/>
    <p:sldId id="295" r:id="rId13"/>
    <p:sldId id="256" r:id="rId14"/>
    <p:sldId id="297" r:id="rId15"/>
    <p:sldId id="263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ric-Bernstam,Funda" initials="M [2]" lastIdx="8" clrIdx="0">
    <p:extLst>
      <p:ext uri="{19B8F6BF-5375-455C-9EA6-DF929625EA0E}">
        <p15:presenceInfo xmlns:p15="http://schemas.microsoft.com/office/powerpoint/2012/main" userId="S::fmeric@mdanderson.org::93eb2aa4-a862-453f-ac07-7a96bbf61352" providerId="AD"/>
      </p:ext>
    </p:extLst>
  </p:cmAuthor>
  <p:cmAuthor id="2" name="Zhao,Ming" initials="Z" lastIdx="10" clrIdx="1">
    <p:extLst>
      <p:ext uri="{19B8F6BF-5375-455C-9EA6-DF929625EA0E}">
        <p15:presenceInfo xmlns:p15="http://schemas.microsoft.com/office/powerpoint/2012/main" userId="S::MZhao6@mdanderson.org::2e9b2efb-d88b-4a22-9b59-52bca83cb44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image" Target="../media/image3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FF395B-6068-46C4-A0C8-2C98D897A2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7DC7A1-8F27-4458-AFF1-46CDB910DF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6FD129-AE5A-4A65-BD0E-2BD2DE827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60D4D9-9FE0-487A-8963-D0806067B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569B49-82B6-46D2-B946-E00D365F2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1067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E36BE-0ABB-4A77-BB87-7221293DE1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DC9CB6-EFDE-4A5A-B035-B342B0A8CE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D14FEC-3131-46FF-AF10-AEA62B337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E992F0-FC16-43CA-BD49-B6F80FE96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825353-D69B-4807-B49C-08E4D6DFC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4850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84B6351-2648-492D-841F-62B0170F26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FC1C5F-5332-4220-B903-C313EBDD8D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1C5103-3C8C-40F8-81C3-8460B29F7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9979A1-57D8-400D-8AF5-5FBA30DD2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35C144-3D17-49C3-BE36-9A09CCB32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4251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8138A-C8A6-4B65-BCF9-7C104D35AC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4399C2-F3B8-4BB3-8443-077C3590D2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924B41-1200-4090-85A7-14D8E05E9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44AD98-7177-45A1-8438-A61C6D17C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4E7727-60FE-4ED1-B3B1-4325575FC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7253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259E23-0AB9-40F0-8B7C-F1685B3887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93D918-9CE7-45CC-BC18-151EB5BEA9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047CF5-EE34-42A3-AD73-414D0A477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A1E326-0FAF-4964-9E1F-497155507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385FBE-EC99-4C2D-8D0C-A3B32BF4F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7735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236DBE-128A-4074-AAE9-95047D4E07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65EE56-76F8-4707-BFB9-283AA4C17F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0A20B8-19D4-427B-BF18-025B815BA2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D64A24-0B83-4328-8491-C4E7E945E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40448E-A56E-4525-90FA-17F0E5CDE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141B75-E97D-4A31-8D61-368877622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3198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FBFC0B-E702-4C8B-A38B-3B67F4931C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A93788-DC8C-479A-A6A1-92A89D98F3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C8645F-5884-415D-BB15-CA4E31D3BF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7FD412-21BA-40D7-8900-B7FF6200B8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A98C5E-D277-4819-B762-B4BB37280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B15202-A4C4-4560-B5B0-33A04334F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60A87BB-B3B1-4A24-9187-9E06DC17F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CA5422-04D6-42E0-AAE5-46C645550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6089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10C61E-5997-4281-917B-BA502EEB88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59A9D7-90F3-4ABF-B1DD-2BD7BCC6F3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3E993A9-087B-4D2B-94FF-EDFD59BAB3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750A55-3F7B-4961-BF57-A70AB950F0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7540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EB66D3-F4DB-46CE-B57F-60034945D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198579-B61B-4263-8394-CDD72B700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4F2436A-9A4A-45FD-AB12-DF8679FFA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1819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74F6CB-FA56-41FA-B93C-909FE12DAE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7C8DEB-52C2-45DE-AAAE-0A20D3D028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E26E81-8AAF-4CF5-837C-471EF95EAA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AF90D8-FB38-4602-BDDA-9707B899D0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D96338-46F2-437C-ACBE-9591D350F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D43BE2-7ED3-4429-87AC-0D5E65798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1259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FB8F9A-EC02-4FE9-A944-3E86FF461A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90EC2C-B48D-4DE6-865E-92DB8AAC7B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A44D91-5835-4B0D-9D68-A1A46EB404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E98357-3702-4253-8CF4-623429E63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F5DA69-AD83-4A4A-B0DD-4F0E3A5FD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A10B3D-D260-4AD8-963C-A4FF8C8C0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303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754FCC-8167-4111-8956-147D64E9A2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5AFF8C-3905-4252-A3EB-E3C5A0B6E3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750ABF-6ECE-4467-8F8C-8E7D773B09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2030A8-2DAC-42C4-97CB-46836235AA15}" type="datetimeFigureOut">
              <a:rPr lang="en-US" smtClean="0"/>
              <a:t>6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628E9B-C96B-484C-B88B-0B6BB29A43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738FC5-B1D1-471D-9F23-0A92CD5996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14C807-35C0-4D65-814E-4CB90C448F5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3728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openxmlformats.org/officeDocument/2006/relationships/image" Target="../media/image10.png"/><Relationship Id="rId26" Type="http://schemas.microsoft.com/office/2007/relationships/hdphoto" Target="../media/hdphoto10.wdp"/><Relationship Id="rId3" Type="http://schemas.microsoft.com/office/2007/relationships/hdphoto" Target="../media/hdphoto1.wdp"/><Relationship Id="rId21" Type="http://schemas.openxmlformats.org/officeDocument/2006/relationships/image" Target="../media/image12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17" Type="http://schemas.microsoft.com/office/2007/relationships/hdphoto" Target="../media/hdphoto7.wdp"/><Relationship Id="rId25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microsoft.com/office/2007/relationships/hdphoto" Target="../media/hdphoto8.wdp"/><Relationship Id="rId29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24" Type="http://schemas.openxmlformats.org/officeDocument/2006/relationships/image" Target="../media/image14.png"/><Relationship Id="rId5" Type="http://schemas.microsoft.com/office/2007/relationships/hdphoto" Target="../media/hdphoto2.wdp"/><Relationship Id="rId15" Type="http://schemas.microsoft.com/office/2007/relationships/hdphoto" Target="../media/hdphoto6.wdp"/><Relationship Id="rId23" Type="http://schemas.microsoft.com/office/2007/relationships/hdphoto" Target="../media/hdphoto9.wdp"/><Relationship Id="rId28" Type="http://schemas.microsoft.com/office/2007/relationships/hdphoto" Target="../media/hdphoto11.wdp"/><Relationship Id="rId10" Type="http://schemas.microsoft.com/office/2007/relationships/hdphoto" Target="../media/hdphoto4.wdp"/><Relationship Id="rId19" Type="http://schemas.openxmlformats.org/officeDocument/2006/relationships/image" Target="../media/image11.png"/><Relationship Id="rId31" Type="http://schemas.openxmlformats.org/officeDocument/2006/relationships/image" Target="../media/image18.png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8.png"/><Relationship Id="rId22" Type="http://schemas.openxmlformats.org/officeDocument/2006/relationships/image" Target="../media/image13.png"/><Relationship Id="rId27" Type="http://schemas.openxmlformats.org/officeDocument/2006/relationships/image" Target="../media/image16.png"/><Relationship Id="rId30" Type="http://schemas.microsoft.com/office/2007/relationships/hdphoto" Target="../media/hdphoto12.wdp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5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9.png"/><Relationship Id="rId3" Type="http://schemas.microsoft.com/office/2007/relationships/hdphoto" Target="../media/hdphoto28.wdp"/><Relationship Id="rId7" Type="http://schemas.microsoft.com/office/2007/relationships/hdphoto" Target="../media/hdphoto30.wdp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8.png"/><Relationship Id="rId5" Type="http://schemas.microsoft.com/office/2007/relationships/hdphoto" Target="../media/hdphoto29.wdp"/><Relationship Id="rId4" Type="http://schemas.openxmlformats.org/officeDocument/2006/relationships/image" Target="../media/image67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png"/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82.png"/><Relationship Id="rId18" Type="http://schemas.microsoft.com/office/2007/relationships/hdphoto" Target="../media/hdphoto32.wdp"/><Relationship Id="rId26" Type="http://schemas.openxmlformats.org/officeDocument/2006/relationships/image" Target="../media/image93.png"/><Relationship Id="rId3" Type="http://schemas.openxmlformats.org/officeDocument/2006/relationships/image" Target="../media/image73.png"/><Relationship Id="rId21" Type="http://schemas.openxmlformats.org/officeDocument/2006/relationships/image" Target="../media/image89.png"/><Relationship Id="rId34" Type="http://schemas.microsoft.com/office/2007/relationships/hdphoto" Target="../media/hdphoto35.wdp"/><Relationship Id="rId7" Type="http://schemas.openxmlformats.org/officeDocument/2006/relationships/image" Target="../media/image77.png"/><Relationship Id="rId12" Type="http://schemas.openxmlformats.org/officeDocument/2006/relationships/image" Target="../media/image81.png"/><Relationship Id="rId17" Type="http://schemas.openxmlformats.org/officeDocument/2006/relationships/image" Target="../media/image86.png"/><Relationship Id="rId25" Type="http://schemas.openxmlformats.org/officeDocument/2006/relationships/image" Target="../media/image92.png"/><Relationship Id="rId33" Type="http://schemas.openxmlformats.org/officeDocument/2006/relationships/image" Target="../media/image99.png"/><Relationship Id="rId2" Type="http://schemas.openxmlformats.org/officeDocument/2006/relationships/image" Target="../media/image72.png"/><Relationship Id="rId16" Type="http://schemas.openxmlformats.org/officeDocument/2006/relationships/image" Target="../media/image85.png"/><Relationship Id="rId20" Type="http://schemas.openxmlformats.org/officeDocument/2006/relationships/image" Target="../media/image88.png"/><Relationship Id="rId29" Type="http://schemas.openxmlformats.org/officeDocument/2006/relationships/image" Target="../media/image9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6.png"/><Relationship Id="rId11" Type="http://schemas.microsoft.com/office/2007/relationships/hdphoto" Target="../media/hdphoto31.wdp"/><Relationship Id="rId24" Type="http://schemas.openxmlformats.org/officeDocument/2006/relationships/image" Target="../media/image91.png"/><Relationship Id="rId32" Type="http://schemas.microsoft.com/office/2007/relationships/hdphoto" Target="../media/hdphoto34.wdp"/><Relationship Id="rId5" Type="http://schemas.openxmlformats.org/officeDocument/2006/relationships/image" Target="../media/image75.png"/><Relationship Id="rId15" Type="http://schemas.openxmlformats.org/officeDocument/2006/relationships/image" Target="../media/image84.png"/><Relationship Id="rId23" Type="http://schemas.microsoft.com/office/2007/relationships/hdphoto" Target="../media/hdphoto33.wdp"/><Relationship Id="rId28" Type="http://schemas.openxmlformats.org/officeDocument/2006/relationships/image" Target="../media/image95.png"/><Relationship Id="rId10" Type="http://schemas.openxmlformats.org/officeDocument/2006/relationships/image" Target="../media/image80.png"/><Relationship Id="rId19" Type="http://schemas.openxmlformats.org/officeDocument/2006/relationships/image" Target="../media/image87.png"/><Relationship Id="rId31" Type="http://schemas.openxmlformats.org/officeDocument/2006/relationships/image" Target="../media/image98.png"/><Relationship Id="rId4" Type="http://schemas.openxmlformats.org/officeDocument/2006/relationships/image" Target="../media/image74.png"/><Relationship Id="rId9" Type="http://schemas.openxmlformats.org/officeDocument/2006/relationships/image" Target="../media/image79.png"/><Relationship Id="rId14" Type="http://schemas.openxmlformats.org/officeDocument/2006/relationships/image" Target="../media/image83.png"/><Relationship Id="rId22" Type="http://schemas.openxmlformats.org/officeDocument/2006/relationships/image" Target="../media/image90.png"/><Relationship Id="rId27" Type="http://schemas.openxmlformats.org/officeDocument/2006/relationships/image" Target="../media/image94.png"/><Relationship Id="rId30" Type="http://schemas.openxmlformats.org/officeDocument/2006/relationships/image" Target="../media/image97.png"/><Relationship Id="rId8" Type="http://schemas.openxmlformats.org/officeDocument/2006/relationships/image" Target="../media/image78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png"/><Relationship Id="rId2" Type="http://schemas.openxmlformats.org/officeDocument/2006/relationships/image" Target="../media/image100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6.wdp"/><Relationship Id="rId5" Type="http://schemas.openxmlformats.org/officeDocument/2006/relationships/image" Target="../media/image103.png"/><Relationship Id="rId4" Type="http://schemas.openxmlformats.org/officeDocument/2006/relationships/image" Target="../media/image102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5.png"/><Relationship Id="rId2" Type="http://schemas.openxmlformats.org/officeDocument/2006/relationships/image" Target="../media/image104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microsoft.com/office/2007/relationships/hdphoto" Target="../media/hdphoto18.wdp"/><Relationship Id="rId3" Type="http://schemas.microsoft.com/office/2007/relationships/hdphoto" Target="../media/hdphoto13.wdp"/><Relationship Id="rId7" Type="http://schemas.microsoft.com/office/2007/relationships/hdphoto" Target="../media/hdphoto15.wdp"/><Relationship Id="rId12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11" Type="http://schemas.microsoft.com/office/2007/relationships/hdphoto" Target="../media/hdphoto17.wdp"/><Relationship Id="rId5" Type="http://schemas.microsoft.com/office/2007/relationships/hdphoto" Target="../media/hdphoto14.wdp"/><Relationship Id="rId15" Type="http://schemas.microsoft.com/office/2007/relationships/hdphoto" Target="../media/hdphoto19.wdp"/><Relationship Id="rId10" Type="http://schemas.openxmlformats.org/officeDocument/2006/relationships/image" Target="../media/image23.png"/><Relationship Id="rId4" Type="http://schemas.openxmlformats.org/officeDocument/2006/relationships/image" Target="../media/image20.png"/><Relationship Id="rId9" Type="http://schemas.microsoft.com/office/2007/relationships/hdphoto" Target="../media/hdphoto16.wdp"/><Relationship Id="rId14" Type="http://schemas.openxmlformats.org/officeDocument/2006/relationships/image" Target="../media/image2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microsoft.com/office/2007/relationships/hdphoto" Target="../media/hdphoto25.wdp"/><Relationship Id="rId3" Type="http://schemas.microsoft.com/office/2007/relationships/hdphoto" Target="../media/hdphoto20.wdp"/><Relationship Id="rId7" Type="http://schemas.microsoft.com/office/2007/relationships/hdphoto" Target="../media/hdphoto22.wdp"/><Relationship Id="rId12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microsoft.com/office/2007/relationships/hdphoto" Target="../media/hdphoto24.wdp"/><Relationship Id="rId5" Type="http://schemas.microsoft.com/office/2007/relationships/hdphoto" Target="../media/hdphoto21.wdp"/><Relationship Id="rId10" Type="http://schemas.openxmlformats.org/officeDocument/2006/relationships/image" Target="../media/image30.png"/><Relationship Id="rId4" Type="http://schemas.openxmlformats.org/officeDocument/2006/relationships/image" Target="../media/image27.png"/><Relationship Id="rId9" Type="http://schemas.microsoft.com/office/2007/relationships/hdphoto" Target="../media/hdphoto23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13" Type="http://schemas.openxmlformats.org/officeDocument/2006/relationships/image" Target="../media/image39.ti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38.ti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3.emf"/><Relationship Id="rId11" Type="http://schemas.openxmlformats.org/officeDocument/2006/relationships/image" Target="../media/image37.ti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36.tif"/><Relationship Id="rId4" Type="http://schemas.openxmlformats.org/officeDocument/2006/relationships/image" Target="../media/image32.emf"/><Relationship Id="rId9" Type="http://schemas.openxmlformats.org/officeDocument/2006/relationships/image" Target="../media/image35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26.wdp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png"/><Relationship Id="rId11" Type="http://schemas.openxmlformats.org/officeDocument/2006/relationships/image" Target="../media/image51.png"/><Relationship Id="rId5" Type="http://schemas.openxmlformats.org/officeDocument/2006/relationships/image" Target="../media/image45.png"/><Relationship Id="rId10" Type="http://schemas.openxmlformats.org/officeDocument/2006/relationships/image" Target="../media/image50.png"/><Relationship Id="rId4" Type="http://schemas.openxmlformats.org/officeDocument/2006/relationships/image" Target="../media/image44.png"/><Relationship Id="rId9" Type="http://schemas.openxmlformats.org/officeDocument/2006/relationships/image" Target="../media/image4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7" Type="http://schemas.microsoft.com/office/2007/relationships/hdphoto" Target="../media/hdphoto27.wdp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6.png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7" Type="http://schemas.openxmlformats.org/officeDocument/2006/relationships/image" Target="../media/image62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1.png"/><Relationship Id="rId5" Type="http://schemas.openxmlformats.org/officeDocument/2006/relationships/image" Target="../media/image60.png"/><Relationship Id="rId4" Type="http://schemas.openxmlformats.org/officeDocument/2006/relationships/image" Target="../media/image5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C31BF5C-6063-4F29-BFE6-A5C88D3685B3}"/>
              </a:ext>
            </a:extLst>
          </p:cNvPr>
          <p:cNvGrpSpPr/>
          <p:nvPr/>
        </p:nvGrpSpPr>
        <p:grpSpPr>
          <a:xfrm>
            <a:off x="3174400" y="202945"/>
            <a:ext cx="7739301" cy="3172596"/>
            <a:chOff x="566598" y="713604"/>
            <a:chExt cx="7739301" cy="317259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2E162A1-DDED-455D-BB91-FA3D1BFD805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390846" y="1865023"/>
              <a:ext cx="3429000" cy="291577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784CC61-0CEE-493F-949B-E812A4891D0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863838" y="1867289"/>
              <a:ext cx="3429000" cy="28006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54D4D4F-91D7-4447-8010-E45BA965105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390846" y="2303369"/>
              <a:ext cx="3429000" cy="234231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3D4B52F-B6A3-4047-83A2-A82A75E7F19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889762" y="2303368"/>
              <a:ext cx="3403076" cy="22153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703C455-E8E0-4077-A08C-028E6BB29DA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390846" y="2684369"/>
              <a:ext cx="3429000" cy="264736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937117A2-256A-4522-8E71-73C3DCD9659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889762" y="2680918"/>
              <a:ext cx="3403076" cy="287041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4E88D76C-735D-4D60-B051-5DCD04DC4FB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390846" y="3034088"/>
              <a:ext cx="3429000" cy="442274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3EF85CD-AA7C-41DD-B2C7-2BD0601524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t="8989" b="6988"/>
            <a:stretch/>
          </p:blipFill>
          <p:spPr>
            <a:xfrm>
              <a:off x="4876800" y="3028360"/>
              <a:ext cx="3403076" cy="452487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042CFA5-F460-42F3-9C3D-6B3D4FFD8DF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390846" y="3623491"/>
              <a:ext cx="3429000" cy="246554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819FDEFD-1B6D-4E4D-ACD5-AA35C080BE82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876800" y="3623490"/>
              <a:ext cx="3403076" cy="26271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40321EC-7308-4121-9B47-B7ED8FD54283}"/>
                </a:ext>
              </a:extLst>
            </p:cNvPr>
            <p:cNvSpPr txBox="1"/>
            <p:nvPr/>
          </p:nvSpPr>
          <p:spPr>
            <a:xfrm>
              <a:off x="693235" y="1879305"/>
              <a:ext cx="7441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DNMT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4B6B5D5-7258-4EA7-912A-29479B2DE24D}"/>
                </a:ext>
              </a:extLst>
            </p:cNvPr>
            <p:cNvSpPr txBox="1"/>
            <p:nvPr/>
          </p:nvSpPr>
          <p:spPr>
            <a:xfrm>
              <a:off x="566598" y="2266595"/>
              <a:ext cx="8483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DNMT3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58176E6-6D00-4335-A21B-CBD60E043248}"/>
                </a:ext>
              </a:extLst>
            </p:cNvPr>
            <p:cNvSpPr txBox="1"/>
            <p:nvPr/>
          </p:nvSpPr>
          <p:spPr>
            <a:xfrm>
              <a:off x="574391" y="2618495"/>
              <a:ext cx="8418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DNMT3B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CC63F41-CA47-4E2F-B736-0F43F3C2D6CA}"/>
                </a:ext>
              </a:extLst>
            </p:cNvPr>
            <p:cNvSpPr txBox="1"/>
            <p:nvPr/>
          </p:nvSpPr>
          <p:spPr>
            <a:xfrm>
              <a:off x="722459" y="3530330"/>
              <a:ext cx="6960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/>
                <a:t>Β</a:t>
              </a:r>
              <a:r>
                <a:rPr lang="en-US" sz="1400" dirty="0"/>
                <a:t>-actin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1D93D1D-80AD-40BB-8648-1DD4B24C5C3B}"/>
                </a:ext>
              </a:extLst>
            </p:cNvPr>
            <p:cNvSpPr txBox="1"/>
            <p:nvPr/>
          </p:nvSpPr>
          <p:spPr>
            <a:xfrm>
              <a:off x="746182" y="3120284"/>
              <a:ext cx="6718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TROP2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B2A05CF-3849-41F7-9809-30DD299127A4}"/>
                </a:ext>
              </a:extLst>
            </p:cNvPr>
            <p:cNvSpPr txBox="1"/>
            <p:nvPr/>
          </p:nvSpPr>
          <p:spPr>
            <a:xfrm rot="16200000">
              <a:off x="1110304" y="1392479"/>
              <a:ext cx="8050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CC-1937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1DEACA6-F671-47AF-8E0B-E32724151C50}"/>
                </a:ext>
              </a:extLst>
            </p:cNvPr>
            <p:cNvSpPr txBox="1"/>
            <p:nvPr/>
          </p:nvSpPr>
          <p:spPr>
            <a:xfrm rot="16200000">
              <a:off x="4936975" y="1473808"/>
              <a:ext cx="6269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BT-474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982FF62-1285-4576-92BA-98D143DE0989}"/>
                </a:ext>
              </a:extLst>
            </p:cNvPr>
            <p:cNvSpPr txBox="1"/>
            <p:nvPr/>
          </p:nvSpPr>
          <p:spPr>
            <a:xfrm rot="16200000">
              <a:off x="3163354" y="1256283"/>
              <a:ext cx="10563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DA-MB-453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7623113-755C-47CA-BF0F-CD338FC0B89C}"/>
                </a:ext>
              </a:extLst>
            </p:cNvPr>
            <p:cNvSpPr txBox="1"/>
            <p:nvPr/>
          </p:nvSpPr>
          <p:spPr>
            <a:xfrm rot="16200000">
              <a:off x="1904182" y="1468752"/>
              <a:ext cx="6495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CC-38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52E9BD8-81BA-40C7-9C4B-5E8F5DEFB259}"/>
                </a:ext>
              </a:extLst>
            </p:cNvPr>
            <p:cNvSpPr txBox="1"/>
            <p:nvPr/>
          </p:nvSpPr>
          <p:spPr>
            <a:xfrm rot="16200000">
              <a:off x="1586570" y="1411382"/>
              <a:ext cx="8066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CC-1806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3A853C4-4D91-4231-9390-DF8A35711CF5}"/>
                </a:ext>
              </a:extLst>
            </p:cNvPr>
            <p:cNvSpPr txBox="1"/>
            <p:nvPr/>
          </p:nvSpPr>
          <p:spPr>
            <a:xfrm rot="16200000">
              <a:off x="2327645" y="1390205"/>
              <a:ext cx="8066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CC-1954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544BAD1-53B1-49FB-94BE-01DB017835A4}"/>
                </a:ext>
              </a:extLst>
            </p:cNvPr>
            <p:cNvSpPr txBox="1"/>
            <p:nvPr/>
          </p:nvSpPr>
          <p:spPr>
            <a:xfrm rot="16200000">
              <a:off x="1344064" y="1393280"/>
              <a:ext cx="8066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CC-1143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B675BDA-5088-4DD8-96D4-76004112805E}"/>
                </a:ext>
              </a:extLst>
            </p:cNvPr>
            <p:cNvSpPr txBox="1"/>
            <p:nvPr/>
          </p:nvSpPr>
          <p:spPr>
            <a:xfrm rot="16200000">
              <a:off x="2893369" y="1237897"/>
              <a:ext cx="10563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DA-MB-468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8CF4B6B-B8D3-462A-824A-3B8C5450D07A}"/>
                </a:ext>
              </a:extLst>
            </p:cNvPr>
            <p:cNvSpPr txBox="1"/>
            <p:nvPr/>
          </p:nvSpPr>
          <p:spPr>
            <a:xfrm rot="16200000">
              <a:off x="3426223" y="1277990"/>
              <a:ext cx="10563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DA-MB-157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22B4711-289B-43B1-9918-26244047391C}"/>
                </a:ext>
              </a:extLst>
            </p:cNvPr>
            <p:cNvSpPr txBox="1"/>
            <p:nvPr/>
          </p:nvSpPr>
          <p:spPr>
            <a:xfrm rot="16200000">
              <a:off x="3595377" y="1195137"/>
              <a:ext cx="11893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DA-MB-134VI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5C9FB12-C1F0-493E-9B87-CC4BAC72E613}"/>
                </a:ext>
              </a:extLst>
            </p:cNvPr>
            <p:cNvSpPr txBox="1"/>
            <p:nvPr/>
          </p:nvSpPr>
          <p:spPr>
            <a:xfrm rot="16200000">
              <a:off x="2410727" y="1249454"/>
              <a:ext cx="10563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DA-MB-23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ECDAA7E-6CBB-426D-9073-FE6E39B3AC42}"/>
                </a:ext>
              </a:extLst>
            </p:cNvPr>
            <p:cNvSpPr txBox="1"/>
            <p:nvPr/>
          </p:nvSpPr>
          <p:spPr>
            <a:xfrm rot="16200000">
              <a:off x="4085261" y="1190626"/>
              <a:ext cx="12310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DA-MB-175VII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7711170-255A-484B-AE1E-D083A340DB41}"/>
                </a:ext>
              </a:extLst>
            </p:cNvPr>
            <p:cNvSpPr txBox="1"/>
            <p:nvPr/>
          </p:nvSpPr>
          <p:spPr>
            <a:xfrm rot="16200000">
              <a:off x="2671944" y="1277429"/>
              <a:ext cx="10563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DA-MB-436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E1F8D93-E015-41DD-8A81-1D3C3A151029}"/>
                </a:ext>
              </a:extLst>
            </p:cNvPr>
            <p:cNvSpPr txBox="1"/>
            <p:nvPr/>
          </p:nvSpPr>
          <p:spPr>
            <a:xfrm rot="16200000">
              <a:off x="7583239" y="1460003"/>
              <a:ext cx="6431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Au-56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A478F1F-31C0-4E85-8EA6-B5955ECA2BCB}"/>
                </a:ext>
              </a:extLst>
            </p:cNvPr>
            <p:cNvSpPr txBox="1"/>
            <p:nvPr/>
          </p:nvSpPr>
          <p:spPr>
            <a:xfrm rot="16200000">
              <a:off x="6558694" y="1434574"/>
              <a:ext cx="6655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CAMA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3ADF7ED-3F0B-417F-88F4-684D3E78C4F3}"/>
                </a:ext>
              </a:extLst>
            </p:cNvPr>
            <p:cNvSpPr txBox="1"/>
            <p:nvPr/>
          </p:nvSpPr>
          <p:spPr>
            <a:xfrm rot="16200000">
              <a:off x="6286084" y="1382323"/>
              <a:ext cx="8066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FM-223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745F56D-5910-4978-AF78-D4D959CA33E5}"/>
                </a:ext>
              </a:extLst>
            </p:cNvPr>
            <p:cNvSpPr txBox="1"/>
            <p:nvPr/>
          </p:nvSpPr>
          <p:spPr>
            <a:xfrm rot="16200000">
              <a:off x="4682810" y="1455143"/>
              <a:ext cx="6269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BT-549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F86FDF8C-2470-4521-A2CE-2FC7BFA37129}"/>
                </a:ext>
              </a:extLst>
            </p:cNvPr>
            <p:cNvSpPr txBox="1"/>
            <p:nvPr/>
          </p:nvSpPr>
          <p:spPr>
            <a:xfrm rot="16200000">
              <a:off x="6962724" y="1345643"/>
              <a:ext cx="86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BCX-011CL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FC589FA-36A2-436D-85E8-D27390B45EEA}"/>
                </a:ext>
              </a:extLst>
            </p:cNvPr>
            <p:cNvSpPr txBox="1"/>
            <p:nvPr/>
          </p:nvSpPr>
          <p:spPr>
            <a:xfrm rot="16200000">
              <a:off x="5638127" y="1462383"/>
              <a:ext cx="6864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SK-BR-3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042B9F8-693E-4C20-9450-301D0BEDF641}"/>
                </a:ext>
              </a:extLst>
            </p:cNvPr>
            <p:cNvSpPr txBox="1"/>
            <p:nvPr/>
          </p:nvSpPr>
          <p:spPr>
            <a:xfrm rot="16200000">
              <a:off x="5953037" y="1527697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T47D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83E8CC5-DABC-4359-BCED-F27C9A6EDAB1}"/>
                </a:ext>
              </a:extLst>
            </p:cNvPr>
            <p:cNvSpPr txBox="1"/>
            <p:nvPr/>
          </p:nvSpPr>
          <p:spPr>
            <a:xfrm rot="16200000">
              <a:off x="5459802" y="1483532"/>
              <a:ext cx="5966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CF-7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A86E7AF-A222-4ECB-9D33-800E3132905B}"/>
                </a:ext>
              </a:extLst>
            </p:cNvPr>
            <p:cNvSpPr txBox="1"/>
            <p:nvPr/>
          </p:nvSpPr>
          <p:spPr>
            <a:xfrm rot="16200000">
              <a:off x="6105468" y="1425386"/>
              <a:ext cx="7280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SUM159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A91FA98-243F-4EC6-A0DB-17BEBE62FED5}"/>
                </a:ext>
              </a:extLst>
            </p:cNvPr>
            <p:cNvSpPr txBox="1"/>
            <p:nvPr/>
          </p:nvSpPr>
          <p:spPr>
            <a:xfrm rot="16200000">
              <a:off x="6702942" y="1342601"/>
              <a:ext cx="86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BCX-010CL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E4D1EB8-775C-4D9B-8119-34EEF80766C9}"/>
                </a:ext>
              </a:extLst>
            </p:cNvPr>
            <p:cNvSpPr txBox="1"/>
            <p:nvPr/>
          </p:nvSpPr>
          <p:spPr>
            <a:xfrm rot="16200000">
              <a:off x="7221798" y="1332029"/>
              <a:ext cx="8749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DX-007CL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5FDFE16-CB55-4B22-8233-54B67A6C24A0}"/>
                </a:ext>
              </a:extLst>
            </p:cNvPr>
            <p:cNvSpPr txBox="1"/>
            <p:nvPr/>
          </p:nvSpPr>
          <p:spPr>
            <a:xfrm rot="16200000">
              <a:off x="2149791" y="1470096"/>
              <a:ext cx="6495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CC-7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CCE9AFC-DD4A-4A05-8B4D-A30CC03C1747}"/>
                </a:ext>
              </a:extLst>
            </p:cNvPr>
            <p:cNvSpPr txBox="1"/>
            <p:nvPr/>
          </p:nvSpPr>
          <p:spPr>
            <a:xfrm rot="16200000">
              <a:off x="3899067" y="1294326"/>
              <a:ext cx="10563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DA-MB-361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E1AFD4D-087F-4FF8-807F-6BCE19EBC783}"/>
                </a:ext>
              </a:extLst>
            </p:cNvPr>
            <p:cNvSpPr txBox="1"/>
            <p:nvPr/>
          </p:nvSpPr>
          <p:spPr>
            <a:xfrm rot="16200000">
              <a:off x="5239820" y="1512074"/>
              <a:ext cx="5483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BT-20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D9D7190-2DA0-4947-825A-5B48BB054ECC}"/>
                </a:ext>
              </a:extLst>
            </p:cNvPr>
            <p:cNvSpPr txBox="1"/>
            <p:nvPr/>
          </p:nvSpPr>
          <p:spPr>
            <a:xfrm rot="16200000">
              <a:off x="7883508" y="1499121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JIMT1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4632C740-204C-44D0-A660-28B15BC66E04}"/>
              </a:ext>
            </a:extLst>
          </p:cNvPr>
          <p:cNvGrpSpPr/>
          <p:nvPr/>
        </p:nvGrpSpPr>
        <p:grpSpPr>
          <a:xfrm>
            <a:off x="977077" y="3795763"/>
            <a:ext cx="3119862" cy="1635002"/>
            <a:chOff x="5529766" y="2654143"/>
            <a:chExt cx="3119862" cy="1635002"/>
          </a:xfrm>
        </p:grpSpPr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105752F4-B567-43B7-B38B-A57FFCAEE691}"/>
                </a:ext>
              </a:extLst>
            </p:cNvPr>
            <p:cNvGrpSpPr/>
            <p:nvPr/>
          </p:nvGrpSpPr>
          <p:grpSpPr>
            <a:xfrm>
              <a:off x="6754539" y="3079294"/>
              <a:ext cx="1644743" cy="1180592"/>
              <a:chOff x="6754539" y="3079294"/>
              <a:chExt cx="1621153" cy="1180592"/>
            </a:xfrm>
          </p:grpSpPr>
          <p:pic>
            <p:nvPicPr>
              <p:cNvPr id="60" name="Picture 59">
                <a:extLst>
                  <a:ext uri="{FF2B5EF4-FFF2-40B4-BE49-F238E27FC236}">
                    <a16:creationId xmlns:a16="http://schemas.microsoft.com/office/drawing/2014/main" id="{91AC7A83-73A8-4D2D-BEB3-3BBA5144B3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1538" t="-1" r="3658" b="-909"/>
              <a:stretch/>
            </p:blipFill>
            <p:spPr>
              <a:xfrm>
                <a:off x="6785965" y="3382310"/>
                <a:ext cx="1580870" cy="198845"/>
              </a:xfrm>
              <a:prstGeom prst="rect">
                <a:avLst/>
              </a:prstGeom>
            </p:spPr>
          </p:pic>
          <p:pic>
            <p:nvPicPr>
              <p:cNvPr id="61" name="Picture 60">
                <a:extLst>
                  <a:ext uri="{FF2B5EF4-FFF2-40B4-BE49-F238E27FC236}">
                    <a16:creationId xmlns:a16="http://schemas.microsoft.com/office/drawing/2014/main" id="{D585EAA0-1BA1-4FFC-BA9B-F266E685BE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1" r="47872" b="8502"/>
              <a:stretch/>
            </p:blipFill>
            <p:spPr>
              <a:xfrm>
                <a:off x="6754539" y="3079294"/>
                <a:ext cx="1611721" cy="227008"/>
              </a:xfrm>
              <a:prstGeom prst="rect">
                <a:avLst/>
              </a:prstGeom>
            </p:spPr>
          </p:pic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8335E8B8-7B52-451D-AB0B-EDCE21229A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r="3744" b="4894"/>
              <a:stretch/>
            </p:blipFill>
            <p:spPr>
              <a:xfrm>
                <a:off x="6785965" y="3687624"/>
                <a:ext cx="1589727" cy="268870"/>
              </a:xfrm>
              <a:prstGeom prst="rect">
                <a:avLst/>
              </a:prstGeom>
            </p:spPr>
          </p:pic>
          <p:pic>
            <p:nvPicPr>
              <p:cNvPr id="63" name="Picture 62">
                <a:extLst>
                  <a:ext uri="{FF2B5EF4-FFF2-40B4-BE49-F238E27FC236}">
                    <a16:creationId xmlns:a16="http://schemas.microsoft.com/office/drawing/2014/main" id="{70D7FA40-24C4-4434-89BC-3880217BB2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6785964" y="4041406"/>
                <a:ext cx="1580295" cy="218480"/>
              </a:xfrm>
              <a:prstGeom prst="rect">
                <a:avLst/>
              </a:prstGeom>
            </p:spPr>
          </p:pic>
        </p:grp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8075F8F4-6016-4FFE-B6A6-ABC145933CB0}"/>
                </a:ext>
              </a:extLst>
            </p:cNvPr>
            <p:cNvSpPr txBox="1"/>
            <p:nvPr/>
          </p:nvSpPr>
          <p:spPr>
            <a:xfrm>
              <a:off x="6129777" y="3100367"/>
              <a:ext cx="6639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NMT1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21883320-125B-43B5-B287-2CEF155D5CC9}"/>
                </a:ext>
              </a:extLst>
            </p:cNvPr>
            <p:cNvSpPr txBox="1"/>
            <p:nvPr/>
          </p:nvSpPr>
          <p:spPr>
            <a:xfrm>
              <a:off x="6077173" y="3388276"/>
              <a:ext cx="7537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NMT3A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085933C-7753-4ABF-966D-7E9894C187B9}"/>
                </a:ext>
              </a:extLst>
            </p:cNvPr>
            <p:cNvSpPr txBox="1"/>
            <p:nvPr/>
          </p:nvSpPr>
          <p:spPr>
            <a:xfrm>
              <a:off x="6077173" y="3683660"/>
              <a:ext cx="7473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NMT3B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B665C47-240D-4831-8AB6-860EA1D2C6EA}"/>
                </a:ext>
              </a:extLst>
            </p:cNvPr>
            <p:cNvSpPr txBox="1"/>
            <p:nvPr/>
          </p:nvSpPr>
          <p:spPr>
            <a:xfrm>
              <a:off x="6196740" y="4012146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/>
                <a:t>Β</a:t>
              </a:r>
              <a:r>
                <a:rPr lang="en-US" sz="1200" dirty="0"/>
                <a:t>-actin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BD360B7-D844-4175-82B2-616CB1583AEA}"/>
                </a:ext>
              </a:extLst>
            </p:cNvPr>
            <p:cNvSpPr txBox="1"/>
            <p:nvPr/>
          </p:nvSpPr>
          <p:spPr>
            <a:xfrm>
              <a:off x="5529766" y="2858087"/>
              <a:ext cx="29111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ecitabine (1 µM):  </a:t>
              </a:r>
              <a:r>
                <a:rPr 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-  +  -  +  -  +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4EB078DD-554D-4216-86F9-CA08474D3BBF}"/>
                </a:ext>
              </a:extLst>
            </p:cNvPr>
            <p:cNvCxnSpPr/>
            <p:nvPr/>
          </p:nvCxnSpPr>
          <p:spPr>
            <a:xfrm>
              <a:off x="6817423" y="2886368"/>
              <a:ext cx="45257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A80C2401-231D-4BA7-94D4-64753D8E5C47}"/>
                </a:ext>
              </a:extLst>
            </p:cNvPr>
            <p:cNvCxnSpPr/>
            <p:nvPr/>
          </p:nvCxnSpPr>
          <p:spPr>
            <a:xfrm>
              <a:off x="7372546" y="2886368"/>
              <a:ext cx="45257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491A7B75-38E1-4759-9D0A-D8E41F585613}"/>
                </a:ext>
              </a:extLst>
            </p:cNvPr>
            <p:cNvCxnSpPr/>
            <p:nvPr/>
          </p:nvCxnSpPr>
          <p:spPr>
            <a:xfrm>
              <a:off x="7918278" y="2889705"/>
              <a:ext cx="45257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2F860782-22EE-4640-BE35-DE4B1D4D359E}"/>
                </a:ext>
              </a:extLst>
            </p:cNvPr>
            <p:cNvSpPr txBox="1"/>
            <p:nvPr/>
          </p:nvSpPr>
          <p:spPr>
            <a:xfrm>
              <a:off x="6599067" y="2654143"/>
              <a:ext cx="20505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MDAMB468    BT549   MDAMB134</a:t>
              </a:r>
            </a:p>
          </p:txBody>
        </p:sp>
      </p:grpSp>
      <p:sp>
        <p:nvSpPr>
          <p:cNvPr id="77" name="TextBox 7">
            <a:extLst>
              <a:ext uri="{FF2B5EF4-FFF2-40B4-BE49-F238E27FC236}">
                <a16:creationId xmlns:a16="http://schemas.microsoft.com/office/drawing/2014/main" id="{F9FEE450-1CF9-4D47-9CB9-FEE862B4FC0F}"/>
              </a:ext>
            </a:extLst>
          </p:cNvPr>
          <p:cNvSpPr txBox="1"/>
          <p:nvPr/>
        </p:nvSpPr>
        <p:spPr>
          <a:xfrm>
            <a:off x="3480523" y="474597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8" name="TextBox 7">
            <a:extLst>
              <a:ext uri="{FF2B5EF4-FFF2-40B4-BE49-F238E27FC236}">
                <a16:creationId xmlns:a16="http://schemas.microsoft.com/office/drawing/2014/main" id="{F7E34DA2-55FD-4716-9650-BA3D63E894B2}"/>
              </a:ext>
            </a:extLst>
          </p:cNvPr>
          <p:cNvSpPr txBox="1"/>
          <p:nvPr/>
        </p:nvSpPr>
        <p:spPr>
          <a:xfrm>
            <a:off x="1521096" y="3507049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9" name="TextBox 7">
            <a:extLst>
              <a:ext uri="{FF2B5EF4-FFF2-40B4-BE49-F238E27FC236}">
                <a16:creationId xmlns:a16="http://schemas.microsoft.com/office/drawing/2014/main" id="{DE0884F8-363F-46F5-9B20-91553DC689A1}"/>
              </a:ext>
            </a:extLst>
          </p:cNvPr>
          <p:cNvSpPr txBox="1"/>
          <p:nvPr/>
        </p:nvSpPr>
        <p:spPr>
          <a:xfrm>
            <a:off x="5827648" y="3693122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66" name="Group 65">
            <a:extLst>
              <a:ext uri="{FF2B5EF4-FFF2-40B4-BE49-F238E27FC236}">
                <a16:creationId xmlns:a16="http://schemas.microsoft.com/office/drawing/2014/main" id="{415BB4EB-525F-48BB-BE9D-DF0177AC24A2}"/>
              </a:ext>
            </a:extLst>
          </p:cNvPr>
          <p:cNvGrpSpPr/>
          <p:nvPr/>
        </p:nvGrpSpPr>
        <p:grpSpPr>
          <a:xfrm>
            <a:off x="5220861" y="3926066"/>
            <a:ext cx="4554452" cy="1341244"/>
            <a:chOff x="1322570" y="1871051"/>
            <a:chExt cx="5259254" cy="1788132"/>
          </a:xfrm>
        </p:grpSpPr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0C615ECA-B94A-4BBA-9A85-089B6BC881F2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654958" y="3400841"/>
              <a:ext cx="2873210" cy="258342"/>
            </a:xfrm>
            <a:prstGeom prst="rect">
              <a:avLst/>
            </a:prstGeom>
          </p:spPr>
        </p:pic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F028F875-8FAC-4CA2-9C97-EF70A24E88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666742" y="2667000"/>
              <a:ext cx="2875878" cy="258341"/>
            </a:xfrm>
            <a:prstGeom prst="rect">
              <a:avLst/>
            </a:prstGeom>
          </p:spPr>
        </p:pic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529FCCE1-BB1A-43A2-927C-AE8A8A2CE57F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-3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666742" y="2962514"/>
              <a:ext cx="2873210" cy="335406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E14EB2E7-C0F2-4DA8-850F-55C80D706B33}"/>
                </a:ext>
              </a:extLst>
            </p:cNvPr>
            <p:cNvSpPr txBox="1"/>
            <p:nvPr/>
          </p:nvSpPr>
          <p:spPr>
            <a:xfrm>
              <a:off x="3004968" y="2657928"/>
              <a:ext cx="766713" cy="369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NMT1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D88B7236-5BA8-4F28-92FC-95F97598EAC9}"/>
                </a:ext>
              </a:extLst>
            </p:cNvPr>
            <p:cNvSpPr txBox="1"/>
            <p:nvPr/>
          </p:nvSpPr>
          <p:spPr>
            <a:xfrm>
              <a:off x="3038672" y="2980088"/>
              <a:ext cx="696520" cy="369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TROP2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17DB7FFA-12B0-4716-9EB1-5755B5BB032A}"/>
                </a:ext>
              </a:extLst>
            </p:cNvPr>
            <p:cNvSpPr txBox="1"/>
            <p:nvPr/>
          </p:nvSpPr>
          <p:spPr>
            <a:xfrm>
              <a:off x="3018458" y="3265461"/>
              <a:ext cx="716734" cy="369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  <a:endParaRPr lang="en-US" sz="1200" dirty="0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E8B7DCB1-0572-4605-BD5A-01AEC8C26B67}"/>
                </a:ext>
              </a:extLst>
            </p:cNvPr>
            <p:cNvSpPr txBox="1"/>
            <p:nvPr/>
          </p:nvSpPr>
          <p:spPr>
            <a:xfrm>
              <a:off x="1322570" y="2129329"/>
              <a:ext cx="5259254" cy="6154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SK-3685032 (10 µM):  -  -  +  -  -  +  -  -  +</a:t>
              </a:r>
            </a:p>
            <a:p>
              <a:r>
                <a:rPr 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Decitabine (1 µM):  -  +  -  -  +  -  -  +  -</a:t>
              </a: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40A8FA43-4564-4DD5-8F3B-D9694C67B52A}"/>
                </a:ext>
              </a:extLst>
            </p:cNvPr>
            <p:cNvCxnSpPr/>
            <p:nvPr/>
          </p:nvCxnSpPr>
          <p:spPr>
            <a:xfrm>
              <a:off x="3724088" y="2196705"/>
              <a:ext cx="82905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E0E87A4E-BB99-41C1-96E3-AE1C0182AC6C}"/>
                </a:ext>
              </a:extLst>
            </p:cNvPr>
            <p:cNvCxnSpPr/>
            <p:nvPr/>
          </p:nvCxnSpPr>
          <p:spPr>
            <a:xfrm>
              <a:off x="4688818" y="2196705"/>
              <a:ext cx="82905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3B8F0BBF-8931-45A3-95A3-4CEEFE1C39BE}"/>
                </a:ext>
              </a:extLst>
            </p:cNvPr>
            <p:cNvCxnSpPr/>
            <p:nvPr/>
          </p:nvCxnSpPr>
          <p:spPr>
            <a:xfrm>
              <a:off x="5648227" y="2198536"/>
              <a:ext cx="82905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39B8542F-22E2-45A9-A4B8-44F76FB54F8C}"/>
                </a:ext>
              </a:extLst>
            </p:cNvPr>
            <p:cNvSpPr txBox="1"/>
            <p:nvPr/>
          </p:nvSpPr>
          <p:spPr>
            <a:xfrm>
              <a:off x="3664737" y="1871051"/>
              <a:ext cx="2876931" cy="369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BCX-010CL     BCX-011CL      SUM159</a:t>
              </a:r>
            </a:p>
          </p:txBody>
        </p: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EE7CF320-D6D0-4405-8AA6-569B9A3DC72F}"/>
              </a:ext>
            </a:extLst>
          </p:cNvPr>
          <p:cNvGrpSpPr/>
          <p:nvPr/>
        </p:nvGrpSpPr>
        <p:grpSpPr>
          <a:xfrm>
            <a:off x="952504" y="738111"/>
            <a:ext cx="1788361" cy="2366361"/>
            <a:chOff x="4761119" y="1424404"/>
            <a:chExt cx="1788361" cy="2366361"/>
          </a:xfrm>
        </p:grpSpPr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B8DE6101-1ABD-4CE2-957F-52DCC7302D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5248275" y="2752725"/>
              <a:ext cx="1301205" cy="1038040"/>
            </a:xfrm>
            <a:prstGeom prst="rect">
              <a:avLst/>
            </a:prstGeom>
          </p:spPr>
        </p:pic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8AF05CEB-C2F7-4302-A2C5-27E7ABE87A52}"/>
                </a:ext>
              </a:extLst>
            </p:cNvPr>
            <p:cNvSpPr txBox="1"/>
            <p:nvPr/>
          </p:nvSpPr>
          <p:spPr>
            <a:xfrm>
              <a:off x="4865510" y="2772895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ZEB1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C93762B5-69F4-45D1-B4EA-ED31D37E234F}"/>
                </a:ext>
              </a:extLst>
            </p:cNvPr>
            <p:cNvSpPr txBox="1"/>
            <p:nvPr/>
          </p:nvSpPr>
          <p:spPr>
            <a:xfrm>
              <a:off x="4761119" y="3481110"/>
              <a:ext cx="58221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en-US" sz="1100" dirty="0"/>
                <a:t>-actin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A9FA5E5E-14F0-4110-A015-592D3C39AA29}"/>
                </a:ext>
              </a:extLst>
            </p:cNvPr>
            <p:cNvSpPr txBox="1"/>
            <p:nvPr/>
          </p:nvSpPr>
          <p:spPr>
            <a:xfrm rot="16200000">
              <a:off x="4810352" y="2067208"/>
              <a:ext cx="12458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BCX-011CL control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225BB63-3A9D-48FD-8E6E-98436D762B35}"/>
                </a:ext>
              </a:extLst>
            </p:cNvPr>
            <p:cNvSpPr txBox="1"/>
            <p:nvPr/>
          </p:nvSpPr>
          <p:spPr>
            <a:xfrm rot="16200000">
              <a:off x="5058364" y="1991867"/>
              <a:ext cx="13965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BCX-011 ZEB1 shRNA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A2AB6C39-1FC9-4F1C-A242-3E7CF7872898}"/>
                </a:ext>
              </a:extLst>
            </p:cNvPr>
            <p:cNvSpPr txBox="1"/>
            <p:nvPr/>
          </p:nvSpPr>
          <p:spPr>
            <a:xfrm rot="16200000">
              <a:off x="5496568" y="2136939"/>
              <a:ext cx="111601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SUM159 control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6567458B-83B7-42D7-9790-6B64F64356FE}"/>
                </a:ext>
              </a:extLst>
            </p:cNvPr>
            <p:cNvSpPr txBox="1"/>
            <p:nvPr/>
          </p:nvSpPr>
          <p:spPr>
            <a:xfrm rot="16200000">
              <a:off x="5640922" y="1994272"/>
              <a:ext cx="14013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SUM159 ZEB1 shRNA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32115E68-C382-4157-BFB9-3A736B705E66}"/>
                </a:ext>
              </a:extLst>
            </p:cNvPr>
            <p:cNvSpPr txBox="1"/>
            <p:nvPr/>
          </p:nvSpPr>
          <p:spPr>
            <a:xfrm>
              <a:off x="4780305" y="3151025"/>
              <a:ext cx="56778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Calibri" panose="020F0502020204030204" pitchFamily="34" charset="0"/>
                  <a:cs typeface="Calibri" panose="020F0502020204030204" pitchFamily="34" charset="0"/>
                </a:rPr>
                <a:t>TROP2</a:t>
              </a:r>
              <a:endParaRPr lang="en-US" sz="1100" dirty="0"/>
            </a:p>
          </p:txBody>
        </p:sp>
      </p:grpSp>
      <p:sp>
        <p:nvSpPr>
          <p:cNvPr id="90" name="TextBox 7">
            <a:extLst>
              <a:ext uri="{FF2B5EF4-FFF2-40B4-BE49-F238E27FC236}">
                <a16:creationId xmlns:a16="http://schemas.microsoft.com/office/drawing/2014/main" id="{9D14B6F8-548E-48E9-AB1C-5F67D6DE3144}"/>
              </a:ext>
            </a:extLst>
          </p:cNvPr>
          <p:cNvSpPr txBox="1"/>
          <p:nvPr/>
        </p:nvSpPr>
        <p:spPr>
          <a:xfrm>
            <a:off x="1027603" y="649063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0BAFCB61-8A66-4D65-AFC9-636F37809A48}"/>
              </a:ext>
            </a:extLst>
          </p:cNvPr>
          <p:cNvSpPr/>
          <p:nvPr/>
        </p:nvSpPr>
        <p:spPr>
          <a:xfrm>
            <a:off x="568463" y="5578279"/>
            <a:ext cx="11286157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1. Regulation of ZEB1 on TROP2 expression and effect of decitabine on DNMTs in breast cancer cell lines. (A)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ZEB1 knockdown by shRNA in BCX-011CL and SUM159 cells. Expression of ZEB1 and TROP2 was examined by immunoblotting. </a:t>
            </a:r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(B)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Immunoblotting screening of DNMTs and TROP2 expression in breast cancer cell lines. </a:t>
            </a:r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(C)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Effect of decitabine on DNMTs. Breast cancer cell lines were treated with decitabine at 1 µM for 3 days. DNMT isoforms were detected by immunoblotting. </a:t>
            </a:r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(D)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Effects of DNMT inhibitor on DNMT1. Breast cancer cell lines were treated with GSK-3685032 at 10 </a:t>
            </a:r>
            <a:r>
              <a:rPr lang="el-GR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μ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M and decitabine at 1 µM for 3 days. DNMT1 and TROP2 levels were examined by immunoblotting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35504318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>
            <a:extLst>
              <a:ext uri="{FF2B5EF4-FFF2-40B4-BE49-F238E27FC236}">
                <a16:creationId xmlns:a16="http://schemas.microsoft.com/office/drawing/2014/main" id="{0F21846A-4A1C-4EB5-B749-BCCD6FA9B8CD}"/>
              </a:ext>
            </a:extLst>
          </p:cNvPr>
          <p:cNvGrpSpPr/>
          <p:nvPr/>
        </p:nvGrpSpPr>
        <p:grpSpPr>
          <a:xfrm>
            <a:off x="2036630" y="1330326"/>
            <a:ext cx="6538764" cy="4696490"/>
            <a:chOff x="1038278" y="1071897"/>
            <a:chExt cx="6538764" cy="4696490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EBE13772-60C2-43CE-9D68-235CAB6D253C}"/>
                </a:ext>
              </a:extLst>
            </p:cNvPr>
            <p:cNvGrpSpPr/>
            <p:nvPr/>
          </p:nvGrpSpPr>
          <p:grpSpPr>
            <a:xfrm>
              <a:off x="1878909" y="1553735"/>
              <a:ext cx="5698133" cy="4028808"/>
              <a:chOff x="3477765" y="2127893"/>
              <a:chExt cx="2493269" cy="2359791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1CA9C99F-7CDC-4CBB-A7C0-C0F76A0EB1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477765" y="2127893"/>
                <a:ext cx="2493269" cy="539497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C32A877E-64DC-4BA2-914E-672CF4A2A1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500145" y="2849064"/>
                <a:ext cx="2449553" cy="722377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73F3D455-4361-48B9-BB1C-58443E6565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477765" y="3753115"/>
                <a:ext cx="2471933" cy="734569"/>
              </a:xfrm>
              <a:prstGeom prst="rect">
                <a:avLst/>
              </a:prstGeom>
            </p:spPr>
          </p:pic>
        </p:grp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52F38C2F-9256-4435-97E2-7FF83D7D19CF}"/>
                </a:ext>
              </a:extLst>
            </p:cNvPr>
            <p:cNvCxnSpPr/>
            <p:nvPr/>
          </p:nvCxnSpPr>
          <p:spPr>
            <a:xfrm>
              <a:off x="3483507" y="1071897"/>
              <a:ext cx="0" cy="464642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79744BED-338E-4EC7-8C0A-D6E69A9BEE90}"/>
                </a:ext>
              </a:extLst>
            </p:cNvPr>
            <p:cNvCxnSpPr/>
            <p:nvPr/>
          </p:nvCxnSpPr>
          <p:spPr>
            <a:xfrm>
              <a:off x="6113293" y="1121959"/>
              <a:ext cx="0" cy="464642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E04D7F8-E010-44E7-9C80-10A89108782D}"/>
                </a:ext>
              </a:extLst>
            </p:cNvPr>
            <p:cNvSpPr txBox="1"/>
            <p:nvPr/>
          </p:nvSpPr>
          <p:spPr>
            <a:xfrm>
              <a:off x="1203953" y="1834068"/>
              <a:ext cx="8066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E-Cad →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CA28186-9255-4A0C-91CF-4EF87D61A00B}"/>
                </a:ext>
              </a:extLst>
            </p:cNvPr>
            <p:cNvSpPr txBox="1"/>
            <p:nvPr/>
          </p:nvSpPr>
          <p:spPr>
            <a:xfrm>
              <a:off x="1123079" y="3387561"/>
              <a:ext cx="873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TROP2 →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6F2C2E8-5F2F-4F7C-B9F8-7193966692A9}"/>
                </a:ext>
              </a:extLst>
            </p:cNvPr>
            <p:cNvSpPr txBox="1"/>
            <p:nvPr/>
          </p:nvSpPr>
          <p:spPr>
            <a:xfrm>
              <a:off x="1038278" y="4982023"/>
              <a:ext cx="8980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/>
                <a:t>Β</a:t>
              </a:r>
              <a:r>
                <a:rPr lang="en-US" sz="1400" dirty="0"/>
                <a:t>-actin →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84A483B-A3C5-4D2A-A223-AB4AC918FC3E}"/>
                </a:ext>
              </a:extLst>
            </p:cNvPr>
            <p:cNvSpPr txBox="1"/>
            <p:nvPr/>
          </p:nvSpPr>
          <p:spPr>
            <a:xfrm>
              <a:off x="2144956" y="1243568"/>
              <a:ext cx="53436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Other samples                       </a:t>
              </a:r>
              <a:r>
                <a:rPr lang="en-US" sz="1600" b="1" dirty="0"/>
                <a:t>Figure 3B samples</a:t>
              </a:r>
              <a:r>
                <a:rPr lang="en-US" sz="1600" dirty="0"/>
                <a:t> </a:t>
              </a:r>
              <a:r>
                <a:rPr lang="en-US" sz="1400" dirty="0"/>
                <a:t>             Other samples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D8E4B926-BBE2-4703-924B-F5467C154FDF}"/>
              </a:ext>
            </a:extLst>
          </p:cNvPr>
          <p:cNvSpPr txBox="1"/>
          <p:nvPr/>
        </p:nvSpPr>
        <p:spPr>
          <a:xfrm>
            <a:off x="3385896" y="530075"/>
            <a:ext cx="463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cropped and unprocessed blots for </a:t>
            </a:r>
            <a:r>
              <a:rPr lang="en-US" b="1" dirty="0"/>
              <a:t>Figure 3B</a:t>
            </a:r>
          </a:p>
        </p:txBody>
      </p:sp>
    </p:spTree>
    <p:extLst>
      <p:ext uri="{BB962C8B-B14F-4D97-AF65-F5344CB8AC3E}">
        <p14:creationId xmlns:p14="http://schemas.microsoft.com/office/powerpoint/2010/main" val="288006872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>
            <a:extLst>
              <a:ext uri="{FF2B5EF4-FFF2-40B4-BE49-F238E27FC236}">
                <a16:creationId xmlns:a16="http://schemas.microsoft.com/office/drawing/2014/main" id="{9BA39328-CA04-4624-9E2C-918A566123B4}"/>
              </a:ext>
            </a:extLst>
          </p:cNvPr>
          <p:cNvGrpSpPr/>
          <p:nvPr/>
        </p:nvGrpSpPr>
        <p:grpSpPr>
          <a:xfrm>
            <a:off x="2709579" y="1049019"/>
            <a:ext cx="5597945" cy="5362421"/>
            <a:chOff x="5878081" y="740675"/>
            <a:chExt cx="5597945" cy="5362421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07C7C898-AF40-4990-866D-4583FA6EFCD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806580" y="740675"/>
              <a:ext cx="4661823" cy="1084521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B3E8A379-507E-4434-8242-6F898928BFD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806580" y="2030772"/>
              <a:ext cx="4661823" cy="1165455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856DC871-C7C0-4E6B-938F-3399FD4394D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814203" y="3311607"/>
              <a:ext cx="4661823" cy="1420747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01143B5E-C162-491E-AC62-C70E9864F4B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876272" y="4851141"/>
              <a:ext cx="4500565" cy="1251955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B14807E-6864-4A51-8B90-9EC8FE2F4C86}"/>
                </a:ext>
              </a:extLst>
            </p:cNvPr>
            <p:cNvSpPr txBox="1"/>
            <p:nvPr/>
          </p:nvSpPr>
          <p:spPr>
            <a:xfrm>
              <a:off x="5930179" y="1054615"/>
              <a:ext cx="9460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DNMT1 →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9FDF01B-4E1B-43D9-BECA-F92BB2B08118}"/>
                </a:ext>
              </a:extLst>
            </p:cNvPr>
            <p:cNvSpPr txBox="1"/>
            <p:nvPr/>
          </p:nvSpPr>
          <p:spPr>
            <a:xfrm>
              <a:off x="5943237" y="2139136"/>
              <a:ext cx="10502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DNMT3A →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42B12CA-2213-42AE-B929-40C3A6D71288}"/>
                </a:ext>
              </a:extLst>
            </p:cNvPr>
            <p:cNvSpPr txBox="1"/>
            <p:nvPr/>
          </p:nvSpPr>
          <p:spPr>
            <a:xfrm>
              <a:off x="5878081" y="3711417"/>
              <a:ext cx="10438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DNMT3B →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88F1CED-9B14-4C74-843C-427916F945C9}"/>
                </a:ext>
              </a:extLst>
            </p:cNvPr>
            <p:cNvSpPr txBox="1"/>
            <p:nvPr/>
          </p:nvSpPr>
          <p:spPr>
            <a:xfrm>
              <a:off x="6023954" y="5305431"/>
              <a:ext cx="8980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/>
                <a:t>Β</a:t>
              </a:r>
              <a:r>
                <a:rPr lang="en-US" sz="1400" dirty="0"/>
                <a:t>-actin →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88FFC449-D825-4B22-B076-D783AED415C0}"/>
              </a:ext>
            </a:extLst>
          </p:cNvPr>
          <p:cNvSpPr txBox="1"/>
          <p:nvPr/>
        </p:nvSpPr>
        <p:spPr>
          <a:xfrm>
            <a:off x="3642001" y="299705"/>
            <a:ext cx="463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cropped and unprocessed blots for </a:t>
            </a:r>
            <a:r>
              <a:rPr lang="en-US" b="1" dirty="0"/>
              <a:t>Figure 3F</a:t>
            </a:r>
          </a:p>
        </p:txBody>
      </p:sp>
    </p:spTree>
    <p:extLst>
      <p:ext uri="{BB962C8B-B14F-4D97-AF65-F5344CB8AC3E}">
        <p14:creationId xmlns:p14="http://schemas.microsoft.com/office/powerpoint/2010/main" val="321385395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>
            <a:extLst>
              <a:ext uri="{FF2B5EF4-FFF2-40B4-BE49-F238E27FC236}">
                <a16:creationId xmlns:a16="http://schemas.microsoft.com/office/drawing/2014/main" id="{9B7BBF18-1457-4ABA-A4B5-9DEF7D89FDB4}"/>
              </a:ext>
            </a:extLst>
          </p:cNvPr>
          <p:cNvGrpSpPr/>
          <p:nvPr/>
        </p:nvGrpSpPr>
        <p:grpSpPr>
          <a:xfrm>
            <a:off x="3629814" y="2275498"/>
            <a:ext cx="4458676" cy="2307004"/>
            <a:chOff x="4866299" y="3752512"/>
            <a:chExt cx="3773852" cy="1968261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CA21B381-F7E8-492E-BE85-8E672271764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66299" y="3752512"/>
              <a:ext cx="3773852" cy="926594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29CF39C5-77F5-4DD8-BC6E-2BED560D036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866299" y="4826130"/>
              <a:ext cx="3773852" cy="894643"/>
            </a:xfrm>
            <a:prstGeom prst="rect">
              <a:avLst/>
            </a:prstGeom>
          </p:spPr>
        </p:pic>
      </p:grp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37EDBC16-7A66-4A85-9AB2-314E94834740}"/>
              </a:ext>
            </a:extLst>
          </p:cNvPr>
          <p:cNvCxnSpPr>
            <a:cxnSpLocks/>
          </p:cNvCxnSpPr>
          <p:nvPr/>
        </p:nvCxnSpPr>
        <p:spPr>
          <a:xfrm>
            <a:off x="5621515" y="1475736"/>
            <a:ext cx="0" cy="326707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7BDE657C-85D9-494B-8299-1B2BB3996A92}"/>
              </a:ext>
            </a:extLst>
          </p:cNvPr>
          <p:cNvSpPr txBox="1"/>
          <p:nvPr/>
        </p:nvSpPr>
        <p:spPr>
          <a:xfrm>
            <a:off x="4330565" y="1806806"/>
            <a:ext cx="13515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igure 4N samples</a:t>
            </a:r>
          </a:p>
          <a:p>
            <a:r>
              <a:rPr lang="en-US" sz="1200" dirty="0"/>
              <a:t>(single cell clones)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64FD80E4-7914-4648-A45C-2F1272DBF17C}"/>
              </a:ext>
            </a:extLst>
          </p:cNvPr>
          <p:cNvCxnSpPr>
            <a:cxnSpLocks/>
          </p:cNvCxnSpPr>
          <p:nvPr/>
        </p:nvCxnSpPr>
        <p:spPr>
          <a:xfrm>
            <a:off x="4307065" y="1480147"/>
            <a:ext cx="0" cy="326707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889E281F-E04E-42A4-A27B-93E6B50AA3CC}"/>
              </a:ext>
            </a:extLst>
          </p:cNvPr>
          <p:cNvSpPr txBox="1"/>
          <p:nvPr/>
        </p:nvSpPr>
        <p:spPr>
          <a:xfrm>
            <a:off x="6040517" y="1949335"/>
            <a:ext cx="16289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ther single cell clone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CE44801-6F15-44E7-AE3D-E1617291038C}"/>
              </a:ext>
            </a:extLst>
          </p:cNvPr>
          <p:cNvSpPr txBox="1"/>
          <p:nvPr/>
        </p:nvSpPr>
        <p:spPr>
          <a:xfrm>
            <a:off x="2717626" y="2801496"/>
            <a:ext cx="873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ROP2 →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06E2078-0321-45D7-89F5-E181C261A6E9}"/>
              </a:ext>
            </a:extLst>
          </p:cNvPr>
          <p:cNvSpPr txBox="1"/>
          <p:nvPr/>
        </p:nvSpPr>
        <p:spPr>
          <a:xfrm>
            <a:off x="2731811" y="3904306"/>
            <a:ext cx="898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/>
              <a:t>Β</a:t>
            </a:r>
            <a:r>
              <a:rPr lang="en-US" sz="1400" dirty="0"/>
              <a:t>-actin →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B15DCB5-1486-454D-B04C-C2DC69E468CC}"/>
              </a:ext>
            </a:extLst>
          </p:cNvPr>
          <p:cNvSpPr txBox="1"/>
          <p:nvPr/>
        </p:nvSpPr>
        <p:spPr>
          <a:xfrm>
            <a:off x="3390205" y="642441"/>
            <a:ext cx="4685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cropped and unprocessed blots for </a:t>
            </a:r>
            <a:r>
              <a:rPr lang="en-US" b="1" dirty="0"/>
              <a:t>Figure 4N</a:t>
            </a:r>
          </a:p>
        </p:txBody>
      </p:sp>
    </p:spTree>
    <p:extLst>
      <p:ext uri="{BB962C8B-B14F-4D97-AF65-F5344CB8AC3E}">
        <p14:creationId xmlns:p14="http://schemas.microsoft.com/office/powerpoint/2010/main" val="285651136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3470ED1-A761-4DE4-BC32-A0CF21CFD7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4128" y="2306779"/>
            <a:ext cx="2554229" cy="72237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1AE1E28-5C1F-44C5-A657-7E9F289A63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2172" y="2335734"/>
            <a:ext cx="2520701" cy="66446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BFE8C59-9362-4646-9A1E-4EF3D77D93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76691" y="312579"/>
            <a:ext cx="2517653" cy="52730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DE01051-3498-4FE7-A092-359526CA6C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84254" y="277274"/>
            <a:ext cx="2496317" cy="54864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597400B-30D9-4060-AEFC-E9D943F3E1C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5184" y="3747850"/>
            <a:ext cx="2511557" cy="42976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B0CC21C-1A7B-4D76-8783-FE2F7B08956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34377" y="3747850"/>
            <a:ext cx="2517653" cy="44805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73506A0-0824-4867-89D0-42FB581D42BC}"/>
              </a:ext>
            </a:extLst>
          </p:cNvPr>
          <p:cNvSpPr txBox="1"/>
          <p:nvPr/>
        </p:nvSpPr>
        <p:spPr>
          <a:xfrm>
            <a:off x="17835" y="3665357"/>
            <a:ext cx="8675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γH2AX →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76EC2DE-2ADD-41E6-B1E4-129E5F8D3D62}"/>
              </a:ext>
            </a:extLst>
          </p:cNvPr>
          <p:cNvSpPr txBox="1"/>
          <p:nvPr/>
        </p:nvSpPr>
        <p:spPr>
          <a:xfrm>
            <a:off x="25438" y="2667966"/>
            <a:ext cx="8367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cPARP</a:t>
            </a:r>
            <a:r>
              <a:rPr lang="en-US" sz="1400" dirty="0"/>
              <a:t> →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092D4E8-9270-44C0-BC29-EB7D9A1F2499}"/>
              </a:ext>
            </a:extLst>
          </p:cNvPr>
          <p:cNvSpPr txBox="1"/>
          <p:nvPr/>
        </p:nvSpPr>
        <p:spPr>
          <a:xfrm>
            <a:off x="6093697" y="651652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KAP1 →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8F6BAC27-5CAB-45ED-88D1-7FFAD21B1C6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81635" y="1771982"/>
            <a:ext cx="2490221" cy="44500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9AF31EC-3235-47FE-861D-1A7EB352960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62142" y="1753536"/>
            <a:ext cx="2490221" cy="451105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B5978376-B2B2-4664-803D-4B89938DF6D1}"/>
              </a:ext>
            </a:extLst>
          </p:cNvPr>
          <p:cNvSpPr txBox="1"/>
          <p:nvPr/>
        </p:nvSpPr>
        <p:spPr>
          <a:xfrm>
            <a:off x="26964" y="1889256"/>
            <a:ext cx="923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LFN11 →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2C08BBFD-AC96-41D9-B634-7374C6661AE9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t="-1053" b="-1053"/>
          <a:stretch/>
        </p:blipFill>
        <p:spPr>
          <a:xfrm>
            <a:off x="826214" y="921499"/>
            <a:ext cx="2551181" cy="737592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2EEC7B6-CBB6-435C-A0F1-EE04F9D9C8F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65887" y="929106"/>
            <a:ext cx="2517653" cy="72237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F834B0D2-FDE7-4B49-86C9-046E8330A596}"/>
              </a:ext>
            </a:extLst>
          </p:cNvPr>
          <p:cNvSpPr txBox="1"/>
          <p:nvPr/>
        </p:nvSpPr>
        <p:spPr>
          <a:xfrm>
            <a:off x="25438" y="1136406"/>
            <a:ext cx="873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ROP2 →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2AE31C2D-28A9-403B-BFFD-0D2EA6FEDFF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25184" y="4272111"/>
            <a:ext cx="2511557" cy="598942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911C293D-BC30-44D7-A950-994CE2131D3E}"/>
              </a:ext>
            </a:extLst>
          </p:cNvPr>
          <p:cNvSpPr txBox="1"/>
          <p:nvPr/>
        </p:nvSpPr>
        <p:spPr>
          <a:xfrm>
            <a:off x="111872" y="4519134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2AX →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7DD76B60-416C-446D-A854-023451DE39D1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434377" y="4253468"/>
            <a:ext cx="2511557" cy="637033"/>
          </a:xfrm>
          <a:prstGeom prst="rect">
            <a:avLst/>
          </a:prstGeom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ECEC9D28-4D72-4A33-B48C-3FBD36F68E1F}"/>
              </a:ext>
            </a:extLst>
          </p:cNvPr>
          <p:cNvGrpSpPr/>
          <p:nvPr/>
        </p:nvGrpSpPr>
        <p:grpSpPr>
          <a:xfrm>
            <a:off x="6096000" y="3070096"/>
            <a:ext cx="5864673" cy="1717406"/>
            <a:chOff x="6096000" y="3606239"/>
            <a:chExt cx="5864673" cy="1717406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3302F48-88B9-429B-B39C-7E3BA5334792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6879547" y="3614603"/>
              <a:ext cx="2548133" cy="94183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3C0B20C-F36A-4C51-AA7F-D3CACA2B6733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9494836" y="3606239"/>
              <a:ext cx="2465837" cy="944882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C9565E6-9306-4193-A45E-D3294A8F9239}"/>
                </a:ext>
              </a:extLst>
            </p:cNvPr>
            <p:cNvSpPr txBox="1"/>
            <p:nvPr/>
          </p:nvSpPr>
          <p:spPr>
            <a:xfrm>
              <a:off x="6096000" y="3663686"/>
              <a:ext cx="8739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pCHK2 →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6BB650D0-83AF-48FA-9384-D315D14E7860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879547" y="4625652"/>
              <a:ext cx="2529845" cy="697993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587F3505-603D-4014-90CB-CD5AF5AED0F7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9547433" y="4650745"/>
              <a:ext cx="2410973" cy="617543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35F0F2B-5531-4D2A-B1DF-0E5DFE75B465}"/>
                </a:ext>
              </a:extLst>
            </p:cNvPr>
            <p:cNvSpPr txBox="1"/>
            <p:nvPr/>
          </p:nvSpPr>
          <p:spPr>
            <a:xfrm>
              <a:off x="6159530" y="4650745"/>
              <a:ext cx="7793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HK2 →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66823813-9EAB-4345-A4F5-B35745CA6266}"/>
              </a:ext>
            </a:extLst>
          </p:cNvPr>
          <p:cNvGrpSpPr/>
          <p:nvPr/>
        </p:nvGrpSpPr>
        <p:grpSpPr>
          <a:xfrm>
            <a:off x="6096000" y="1497438"/>
            <a:ext cx="5893929" cy="1458415"/>
            <a:chOff x="-230184" y="5125090"/>
            <a:chExt cx="5893929" cy="1458415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03C1DEA5-6C58-4359-8FE9-7D65E7C481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 flipH="1">
              <a:off x="549196" y="5836743"/>
              <a:ext cx="2523749" cy="746762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787C0A3-A116-4BE7-BEAF-1E5B30739DAB}"/>
                </a:ext>
              </a:extLst>
            </p:cNvPr>
            <p:cNvSpPr txBox="1"/>
            <p:nvPr/>
          </p:nvSpPr>
          <p:spPr>
            <a:xfrm>
              <a:off x="-186103" y="6056235"/>
              <a:ext cx="7793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CHK1 →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C0912DE2-A3D9-4CB1-AD3F-F3CBFE3272A0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549197" y="5125090"/>
              <a:ext cx="2523749" cy="597409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26E004F-E529-4A55-AC6E-76DF27E76707}"/>
                </a:ext>
              </a:extLst>
            </p:cNvPr>
            <p:cNvSpPr txBox="1"/>
            <p:nvPr/>
          </p:nvSpPr>
          <p:spPr>
            <a:xfrm>
              <a:off x="-230184" y="5239334"/>
              <a:ext cx="8675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pCHK1 →</a:t>
              </a:r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6D99DCA5-5C7F-4A9E-854D-A0A9DB0A5AE1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170476" y="5125090"/>
              <a:ext cx="2493269" cy="621793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B1DE4825-A08E-42C3-AC7F-506E548472C1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3164380" y="5843317"/>
              <a:ext cx="2499365" cy="740188"/>
            </a:xfrm>
            <a:prstGeom prst="rect">
              <a:avLst/>
            </a:prstGeom>
          </p:spPr>
        </p:pic>
      </p:grpSp>
      <p:pic>
        <p:nvPicPr>
          <p:cNvPr id="40" name="Picture 39">
            <a:extLst>
              <a:ext uri="{FF2B5EF4-FFF2-40B4-BE49-F238E27FC236}">
                <a16:creationId xmlns:a16="http://schemas.microsoft.com/office/drawing/2014/main" id="{4C3A578C-BDB9-49A8-918B-5663947C5D2F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6875380" y="922461"/>
            <a:ext cx="2490221" cy="460249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81A6E836-F625-4D80-9917-2A045A4E671C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9506557" y="916229"/>
            <a:ext cx="2474014" cy="481585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FE7A3A3B-0431-4A84-BBE6-58DCADAC0C68}"/>
              </a:ext>
            </a:extLst>
          </p:cNvPr>
          <p:cNvSpPr txBox="1"/>
          <p:nvPr/>
        </p:nvSpPr>
        <p:spPr>
          <a:xfrm>
            <a:off x="6208462" y="1092094"/>
            <a:ext cx="7681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KAP1 →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36097887-9281-40DA-BF15-B44EF4FDCAC5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9548674" y="5611546"/>
            <a:ext cx="2409732" cy="736646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2E684AF0-1369-4E56-9277-FDE87AF86CF2}"/>
              </a:ext>
            </a:extLst>
          </p:cNvPr>
          <p:cNvPicPr>
            <a:picLocks noChangeAspect="1"/>
          </p:cNvPicPr>
          <p:nvPr/>
        </p:nvPicPr>
        <p:blipFill rotWithShape="1">
          <a:blip r:embed="rId28"/>
          <a:srcRect t="14782"/>
          <a:stretch/>
        </p:blipFill>
        <p:spPr>
          <a:xfrm>
            <a:off x="6882596" y="5611546"/>
            <a:ext cx="2556158" cy="740188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CB8DB5E8-9105-4D65-8BF1-256DB7FE983C}"/>
              </a:ext>
            </a:extLst>
          </p:cNvPr>
          <p:cNvSpPr txBox="1"/>
          <p:nvPr/>
        </p:nvSpPr>
        <p:spPr>
          <a:xfrm>
            <a:off x="6021459" y="5859742"/>
            <a:ext cx="898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/>
              <a:t>Β</a:t>
            </a:r>
            <a:r>
              <a:rPr lang="en-US" sz="1400" dirty="0"/>
              <a:t>-actin →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6506ECE3-72F3-4C07-959D-190FD4CF81F2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6890620" y="4856717"/>
            <a:ext cx="2548133" cy="681303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254D6272-2E6E-4181-A94A-2A6BBD4E6473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9529145" y="4854413"/>
            <a:ext cx="2429261" cy="683607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4D85B5B8-FDCF-4BE9-B1B3-25D8581715CE}"/>
              </a:ext>
            </a:extLst>
          </p:cNvPr>
          <p:cNvSpPr txBox="1"/>
          <p:nvPr/>
        </p:nvSpPr>
        <p:spPr>
          <a:xfrm>
            <a:off x="6040908" y="5134159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RAD51 →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50076D4F-C89B-4431-9A05-EA5BD9162E88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14128" y="3059320"/>
            <a:ext cx="2522613" cy="591313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47B052BB-2994-4E16-9F06-28BF0E3AAB49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59792" y="3019664"/>
            <a:ext cx="2511557" cy="649225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D66CAEDB-110A-42BA-85E7-4B70E3A35F45}"/>
              </a:ext>
            </a:extLst>
          </p:cNvPr>
          <p:cNvSpPr txBox="1"/>
          <p:nvPr/>
        </p:nvSpPr>
        <p:spPr>
          <a:xfrm>
            <a:off x="38134" y="3306983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Casp3→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B04C834-B7FE-44F4-80C0-17BF08D5BE95}"/>
              </a:ext>
            </a:extLst>
          </p:cNvPr>
          <p:cNvSpPr txBox="1"/>
          <p:nvPr/>
        </p:nvSpPr>
        <p:spPr>
          <a:xfrm>
            <a:off x="1548041" y="4925270"/>
            <a:ext cx="35157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CX-010CL                                     SUM159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59831B4-E44A-407F-9C58-90486FC68010}"/>
              </a:ext>
            </a:extLst>
          </p:cNvPr>
          <p:cNvSpPr txBox="1"/>
          <p:nvPr/>
        </p:nvSpPr>
        <p:spPr>
          <a:xfrm>
            <a:off x="7789580" y="6348525"/>
            <a:ext cx="35157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CX-010CL                                     SUM159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D8D6D08-FAE3-4D88-A84C-5A6DD9DB4990}"/>
              </a:ext>
            </a:extLst>
          </p:cNvPr>
          <p:cNvSpPr txBox="1"/>
          <p:nvPr/>
        </p:nvSpPr>
        <p:spPr>
          <a:xfrm>
            <a:off x="1036312" y="210412"/>
            <a:ext cx="463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cropped and unprocessed blots for </a:t>
            </a:r>
            <a:r>
              <a:rPr lang="en-US" b="1" dirty="0"/>
              <a:t>Figure 5</a:t>
            </a:r>
          </a:p>
        </p:txBody>
      </p:sp>
    </p:spTree>
    <p:extLst>
      <p:ext uri="{BB962C8B-B14F-4D97-AF65-F5344CB8AC3E}">
        <p14:creationId xmlns:p14="http://schemas.microsoft.com/office/powerpoint/2010/main" val="257580830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327CB888-0F81-4C98-AE6B-2FBA1D6CE1D0}"/>
              </a:ext>
            </a:extLst>
          </p:cNvPr>
          <p:cNvGrpSpPr/>
          <p:nvPr/>
        </p:nvGrpSpPr>
        <p:grpSpPr>
          <a:xfrm>
            <a:off x="4577199" y="918205"/>
            <a:ext cx="2589278" cy="5465539"/>
            <a:chOff x="4802122" y="1137280"/>
            <a:chExt cx="2023876" cy="499416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864A86D-5534-4BBE-952A-3DD8B5FA133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02122" y="1137280"/>
              <a:ext cx="2023876" cy="1612395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0ABF600-6925-4911-B80D-EF14B2A329D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802122" y="2859403"/>
              <a:ext cx="1993396" cy="1615443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BEBE6660-54AD-489A-A0A7-6EA6002113E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846318" y="5488314"/>
              <a:ext cx="1935484" cy="643129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9DCC428-2792-48A3-B3AC-78875B20467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890515" y="4507615"/>
              <a:ext cx="1905003" cy="947930"/>
            </a:xfrm>
            <a:prstGeom prst="rect">
              <a:avLst/>
            </a:prstGeom>
          </p:spPr>
        </p:pic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98CEF388-8768-4676-BC55-C5EBDC760943}"/>
              </a:ext>
            </a:extLst>
          </p:cNvPr>
          <p:cNvSpPr txBox="1"/>
          <p:nvPr/>
        </p:nvSpPr>
        <p:spPr>
          <a:xfrm>
            <a:off x="3072479" y="1433864"/>
            <a:ext cx="15612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LFN11 (lighter) </a:t>
            </a:r>
            <a:r>
              <a:rPr lang="en-US" sz="1400" dirty="0">
                <a:sym typeface="Symbol" panose="05050102010706020507" pitchFamily="18" charset="2"/>
              </a:rPr>
              <a:t></a:t>
            </a:r>
            <a:endParaRPr lang="en-US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B29EC90-95E9-4EDB-87C4-5373A45B45DC}"/>
              </a:ext>
            </a:extLst>
          </p:cNvPr>
          <p:cNvSpPr txBox="1"/>
          <p:nvPr/>
        </p:nvSpPr>
        <p:spPr>
          <a:xfrm>
            <a:off x="3072479" y="3275111"/>
            <a:ext cx="15606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LFN11 (darker) </a:t>
            </a:r>
            <a:r>
              <a:rPr lang="en-US" sz="1400" dirty="0">
                <a:sym typeface="Symbol" panose="05050102010706020507" pitchFamily="18" charset="2"/>
              </a:rPr>
              <a:t></a:t>
            </a:r>
            <a:endParaRPr lang="en-US"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AB2CB4B-1498-48AF-B1E9-2F1F9103D353}"/>
              </a:ext>
            </a:extLst>
          </p:cNvPr>
          <p:cNvSpPr txBox="1"/>
          <p:nvPr/>
        </p:nvSpPr>
        <p:spPr>
          <a:xfrm>
            <a:off x="3800427" y="4798006"/>
            <a:ext cx="8898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ROP2 </a:t>
            </a:r>
            <a:r>
              <a:rPr lang="en-US" sz="1400" dirty="0">
                <a:sym typeface="Symbol" panose="05050102010706020507" pitchFamily="18" charset="2"/>
              </a:rPr>
              <a:t></a:t>
            </a:r>
            <a:endParaRPr lang="en-US" sz="14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23A30F3-1AAF-4AA0-9191-3B6E44BFFA19}"/>
              </a:ext>
            </a:extLst>
          </p:cNvPr>
          <p:cNvSpPr txBox="1"/>
          <p:nvPr/>
        </p:nvSpPr>
        <p:spPr>
          <a:xfrm>
            <a:off x="3735160" y="5939795"/>
            <a:ext cx="898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/>
              <a:t>Β</a:t>
            </a:r>
            <a:r>
              <a:rPr lang="en-US" sz="1400" dirty="0"/>
              <a:t>-actin →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2CE558D-5201-44D3-9D78-7EA582781F3E}"/>
              </a:ext>
            </a:extLst>
          </p:cNvPr>
          <p:cNvSpPr txBox="1"/>
          <p:nvPr/>
        </p:nvSpPr>
        <p:spPr>
          <a:xfrm>
            <a:off x="3415038" y="289590"/>
            <a:ext cx="463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cropped and unprocessed blots for </a:t>
            </a:r>
            <a:r>
              <a:rPr lang="en-US" b="1" dirty="0"/>
              <a:t>Figure 6A</a:t>
            </a:r>
          </a:p>
        </p:txBody>
      </p:sp>
    </p:spTree>
    <p:extLst>
      <p:ext uri="{BB962C8B-B14F-4D97-AF65-F5344CB8AC3E}">
        <p14:creationId xmlns:p14="http://schemas.microsoft.com/office/powerpoint/2010/main" val="223977233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F275B671-A7C6-4046-8E44-752F09FB1AE1}"/>
              </a:ext>
            </a:extLst>
          </p:cNvPr>
          <p:cNvGrpSpPr/>
          <p:nvPr/>
        </p:nvGrpSpPr>
        <p:grpSpPr>
          <a:xfrm>
            <a:off x="2634984" y="1713611"/>
            <a:ext cx="6015294" cy="3829718"/>
            <a:chOff x="2958716" y="1075436"/>
            <a:chExt cx="6015294" cy="382971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02DDA70-4E9A-4563-B569-2ABBB4F5C9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14724"/>
            <a:stretch/>
          </p:blipFill>
          <p:spPr>
            <a:xfrm>
              <a:off x="3817220" y="1641161"/>
              <a:ext cx="5156790" cy="1878215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12BC91B-597F-4DDA-AFA0-16EFF857BD6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17220" y="3599014"/>
              <a:ext cx="5156786" cy="1137897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AE8D81C-39D2-467E-AEAB-A3607ADFE44B}"/>
                </a:ext>
              </a:extLst>
            </p:cNvPr>
            <p:cNvSpPr txBox="1"/>
            <p:nvPr/>
          </p:nvSpPr>
          <p:spPr>
            <a:xfrm>
              <a:off x="2958716" y="2329641"/>
              <a:ext cx="9236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SLFN11 →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1D6F356-CF15-4527-AF53-6D67DA4281B8}"/>
                </a:ext>
              </a:extLst>
            </p:cNvPr>
            <p:cNvSpPr txBox="1"/>
            <p:nvPr/>
          </p:nvSpPr>
          <p:spPr>
            <a:xfrm>
              <a:off x="2971541" y="3953743"/>
              <a:ext cx="8980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/>
                <a:t>Β</a:t>
              </a:r>
              <a:r>
                <a:rPr lang="en-US" sz="1400" dirty="0"/>
                <a:t>-actin →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5FE09EE2-B70E-4420-8371-1FF7BC3FFEEA}"/>
                </a:ext>
              </a:extLst>
            </p:cNvPr>
            <p:cNvCxnSpPr/>
            <p:nvPr/>
          </p:nvCxnSpPr>
          <p:spPr>
            <a:xfrm>
              <a:off x="6602818" y="1075436"/>
              <a:ext cx="0" cy="38297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CC3B94B-6A32-40C0-8A21-83C616B687E9}"/>
                </a:ext>
              </a:extLst>
            </p:cNvPr>
            <p:cNvSpPr txBox="1"/>
            <p:nvPr/>
          </p:nvSpPr>
          <p:spPr>
            <a:xfrm>
              <a:off x="4861389" y="1303641"/>
              <a:ext cx="37008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Other samples                            </a:t>
              </a:r>
              <a:r>
                <a:rPr lang="en-US" sz="1400" b="1" dirty="0"/>
                <a:t>Figure 6D samples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EEE4F2B5-9DDE-4F50-8A20-50BB625C6553}"/>
              </a:ext>
            </a:extLst>
          </p:cNvPr>
          <p:cNvSpPr txBox="1"/>
          <p:nvPr/>
        </p:nvSpPr>
        <p:spPr>
          <a:xfrm>
            <a:off x="3545812" y="567349"/>
            <a:ext cx="4679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cropped and unprocessed blots for </a:t>
            </a:r>
            <a:r>
              <a:rPr lang="en-US" b="1" dirty="0"/>
              <a:t>Figure 6D</a:t>
            </a:r>
          </a:p>
        </p:txBody>
      </p:sp>
    </p:spTree>
    <p:extLst>
      <p:ext uri="{BB962C8B-B14F-4D97-AF65-F5344CB8AC3E}">
        <p14:creationId xmlns:p14="http://schemas.microsoft.com/office/powerpoint/2010/main" val="18946372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60527B0C-4076-44C6-81CC-A22C55FD919F}"/>
              </a:ext>
            </a:extLst>
          </p:cNvPr>
          <p:cNvSpPr txBox="1"/>
          <p:nvPr/>
        </p:nvSpPr>
        <p:spPr>
          <a:xfrm>
            <a:off x="423852" y="1646946"/>
            <a:ext cx="4853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API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E3A680F-4451-4C49-A81F-9D4ECD10EB51}"/>
              </a:ext>
            </a:extLst>
          </p:cNvPr>
          <p:cNvSpPr txBox="1"/>
          <p:nvPr/>
        </p:nvSpPr>
        <p:spPr>
          <a:xfrm>
            <a:off x="23749" y="3979431"/>
            <a:ext cx="12855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G-Alexa-488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7F12EA16-3766-4EC1-A97C-2C73358AC216}"/>
              </a:ext>
            </a:extLst>
          </p:cNvPr>
          <p:cNvGrpSpPr/>
          <p:nvPr/>
        </p:nvGrpSpPr>
        <p:grpSpPr>
          <a:xfrm>
            <a:off x="1046636" y="1062467"/>
            <a:ext cx="5400209" cy="3863956"/>
            <a:chOff x="1082148" y="1871192"/>
            <a:chExt cx="5400209" cy="3863956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A0B565F4-5947-492E-B433-B3B4AA26C2DC}"/>
                </a:ext>
              </a:extLst>
            </p:cNvPr>
            <p:cNvGrpSpPr/>
            <p:nvPr/>
          </p:nvGrpSpPr>
          <p:grpSpPr>
            <a:xfrm>
              <a:off x="3826000" y="1871192"/>
              <a:ext cx="2656357" cy="3863956"/>
              <a:chOff x="3213717" y="171204"/>
              <a:chExt cx="2798408" cy="3934400"/>
            </a:xfrm>
          </p:grpSpPr>
          <p:pic>
            <p:nvPicPr>
              <p:cNvPr id="24" name="Picture 23" descr="A picture containing keyboard, computer, black, close&#10;&#10;Description automatically generated">
                <a:extLst>
                  <a:ext uri="{FF2B5EF4-FFF2-40B4-BE49-F238E27FC236}">
                    <a16:creationId xmlns:a16="http://schemas.microsoft.com/office/drawing/2014/main" id="{E182703D-2A60-497E-8503-1DA3CDB815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5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13718" y="171204"/>
                <a:ext cx="2798407" cy="1915885"/>
              </a:xfrm>
              <a:prstGeom prst="rect">
                <a:avLst/>
              </a:prstGeom>
            </p:spPr>
          </p:pic>
          <p:pic>
            <p:nvPicPr>
              <p:cNvPr id="27" name="Picture 26" descr="A picture containing dark, night sky&#10;&#10;Description automatically generated">
                <a:extLst>
                  <a:ext uri="{FF2B5EF4-FFF2-40B4-BE49-F238E27FC236}">
                    <a16:creationId xmlns:a16="http://schemas.microsoft.com/office/drawing/2014/main" id="{9711A20D-2A2C-42C7-99A7-20F785C539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13717" y="2189719"/>
                <a:ext cx="2798407" cy="1915885"/>
              </a:xfrm>
              <a:prstGeom prst="rect">
                <a:avLst/>
              </a:prstGeom>
            </p:spPr>
          </p:pic>
        </p:grp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2B811FD6-733A-42B8-B58F-756DC233EC3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2148" y="3853566"/>
              <a:ext cx="2656357" cy="1876492"/>
            </a:xfrm>
            <a:prstGeom prst="rect">
              <a:avLst/>
            </a:prstGeom>
          </p:spPr>
        </p:pic>
        <p:pic>
          <p:nvPicPr>
            <p:cNvPr id="23" name="Picture 22" descr="A picture containing black&#10;&#10;Description automatically generated">
              <a:extLst>
                <a:ext uri="{FF2B5EF4-FFF2-40B4-BE49-F238E27FC236}">
                  <a16:creationId xmlns:a16="http://schemas.microsoft.com/office/drawing/2014/main" id="{03D27955-E13D-4145-9C3F-A9EAE606915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5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2150" y="1876282"/>
              <a:ext cx="2656356" cy="1876492"/>
            </a:xfrm>
            <a:prstGeom prst="rect">
              <a:avLst/>
            </a:prstGeom>
          </p:spPr>
        </p:pic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B77B2388-881B-41FA-BC89-F794288FE06F}"/>
              </a:ext>
            </a:extLst>
          </p:cNvPr>
          <p:cNvGrpSpPr/>
          <p:nvPr/>
        </p:nvGrpSpPr>
        <p:grpSpPr>
          <a:xfrm>
            <a:off x="6631995" y="1077351"/>
            <a:ext cx="5400209" cy="3861258"/>
            <a:chOff x="6569849" y="1886076"/>
            <a:chExt cx="5400209" cy="3861258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A4D04C68-378E-44BB-9219-7ECEC5F8ACBB}"/>
                </a:ext>
              </a:extLst>
            </p:cNvPr>
            <p:cNvGrpSpPr/>
            <p:nvPr/>
          </p:nvGrpSpPr>
          <p:grpSpPr>
            <a:xfrm>
              <a:off x="9313703" y="1886076"/>
              <a:ext cx="2656355" cy="3861258"/>
              <a:chOff x="6179877" y="171204"/>
              <a:chExt cx="2798406" cy="3931653"/>
            </a:xfrm>
          </p:grpSpPr>
          <p:pic>
            <p:nvPicPr>
              <p:cNvPr id="32" name="Picture 31" descr="A picture containing indoor, black, night sky&#10;&#10;Description automatically generated">
                <a:extLst>
                  <a:ext uri="{FF2B5EF4-FFF2-40B4-BE49-F238E27FC236}">
                    <a16:creationId xmlns:a16="http://schemas.microsoft.com/office/drawing/2014/main" id="{58057D3C-C965-4B3B-AB3B-22827AD881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79877" y="171204"/>
                <a:ext cx="2798406" cy="1915885"/>
              </a:xfrm>
              <a:prstGeom prst="rect">
                <a:avLst/>
              </a:prstGeom>
            </p:spPr>
          </p:pic>
          <p:pic>
            <p:nvPicPr>
              <p:cNvPr id="33" name="Picture 32" descr="A picture containing control panel, night sky&#10;&#10;Description automatically generated">
                <a:extLst>
                  <a:ext uri="{FF2B5EF4-FFF2-40B4-BE49-F238E27FC236}">
                    <a16:creationId xmlns:a16="http://schemas.microsoft.com/office/drawing/2014/main" id="{39ED36A7-405A-4763-A275-BD12B35770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3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79877" y="2186972"/>
                <a:ext cx="2798406" cy="1915885"/>
              </a:xfrm>
              <a:prstGeom prst="rect">
                <a:avLst/>
              </a:prstGeom>
            </p:spPr>
          </p:pic>
        </p:grp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FD330712-813B-4391-9314-2E45EC3ED42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69849" y="3860945"/>
              <a:ext cx="2656357" cy="1886389"/>
            </a:xfrm>
            <a:prstGeom prst="rect">
              <a:avLst/>
            </a:prstGeom>
          </p:spPr>
        </p:pic>
        <p:pic>
          <p:nvPicPr>
            <p:cNvPr id="31" name="Picture 30" descr="A picture containing indoor, night sky&#10;&#10;Description automatically generated">
              <a:extLst>
                <a:ext uri="{FF2B5EF4-FFF2-40B4-BE49-F238E27FC236}">
                  <a16:creationId xmlns:a16="http://schemas.microsoft.com/office/drawing/2014/main" id="{8641304F-1E16-4F12-BADF-3402DA0B369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69852" y="1886076"/>
              <a:ext cx="2656354" cy="1876492"/>
            </a:xfrm>
            <a:prstGeom prst="rect">
              <a:avLst/>
            </a:prstGeom>
          </p:spPr>
        </p:pic>
      </p:grpSp>
      <p:sp>
        <p:nvSpPr>
          <p:cNvPr id="34" name="Rectangle 33">
            <a:extLst>
              <a:ext uri="{FF2B5EF4-FFF2-40B4-BE49-F238E27FC236}">
                <a16:creationId xmlns:a16="http://schemas.microsoft.com/office/drawing/2014/main" id="{68D5A20C-FAFC-4962-AE3B-55CB5A1B353B}"/>
              </a:ext>
            </a:extLst>
          </p:cNvPr>
          <p:cNvSpPr/>
          <p:nvPr/>
        </p:nvSpPr>
        <p:spPr>
          <a:xfrm>
            <a:off x="994299" y="562875"/>
            <a:ext cx="5492227" cy="4648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F62958EA-8439-4263-9789-DBE5F2D27E7A}"/>
              </a:ext>
            </a:extLst>
          </p:cNvPr>
          <p:cNvSpPr/>
          <p:nvPr/>
        </p:nvSpPr>
        <p:spPr>
          <a:xfrm>
            <a:off x="6574020" y="562873"/>
            <a:ext cx="5535121" cy="46482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EA38C0D-5B63-4231-AE76-F9DE89AA0F9C}"/>
              </a:ext>
            </a:extLst>
          </p:cNvPr>
          <p:cNvSpPr txBox="1"/>
          <p:nvPr/>
        </p:nvSpPr>
        <p:spPr>
          <a:xfrm>
            <a:off x="1514129" y="678607"/>
            <a:ext cx="101486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CX-010CL control                          BCX-010CL-TROP2                              BCX-011CL control                           BCX-011CL-TROP2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F1CA236-B273-4201-9EB4-93874ED942BB}"/>
              </a:ext>
            </a:extLst>
          </p:cNvPr>
          <p:cNvSpPr/>
          <p:nvPr/>
        </p:nvSpPr>
        <p:spPr>
          <a:xfrm>
            <a:off x="815620" y="5443074"/>
            <a:ext cx="1121658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2. Immunofluorescence of SG binding on TROP2-overexpression cell membrane of breast cancer cell lines 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BCX-010CL and BCX-011CL cell lines were transfected with control or TROP2 plasmid. Cells cultured on cover slides were fixed with 4% paraformaldehyde, then incubated with SG- Alexa-488 conjugate at 2 µg/ml at room temperature for 2 hours. The cover slides were mounted onto slide with DAPI counterstaining. Fluorescence on cell surface was monitored with fluorescent microscope (40x magnification)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6774623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5FD8994-D49F-4E23-AC09-241761CAB1E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6384" y="1017571"/>
            <a:ext cx="2354685" cy="175924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9B1DE3A-AA9B-43FB-B907-58B0C7DCECD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6384" y="2895415"/>
            <a:ext cx="2354685" cy="1759247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FFBB158-F227-424B-BB87-E9CB4E030AE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6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5611" y="1017571"/>
            <a:ext cx="2354685" cy="175924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F0F38C6-493F-46E4-A5EE-D7268337F844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5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7536" y="2892987"/>
            <a:ext cx="2354685" cy="1759247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3F6817F-80A8-49CC-B42E-FFD131BFF277}"/>
              </a:ext>
            </a:extLst>
          </p:cNvPr>
          <p:cNvSpPr txBox="1"/>
          <p:nvPr/>
        </p:nvSpPr>
        <p:spPr>
          <a:xfrm>
            <a:off x="2803074" y="760474"/>
            <a:ext cx="6901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robed after cell fixation              Probed 3 hours before cell fixation        probed 24 hours before cell fixation</a:t>
            </a:r>
          </a:p>
        </p:txBody>
      </p:sp>
      <p:pic>
        <p:nvPicPr>
          <p:cNvPr id="12" name="Picture 11" descr="A picture containing night sky&#10;&#10;Description automatically generated">
            <a:extLst>
              <a:ext uri="{FF2B5EF4-FFF2-40B4-BE49-F238E27FC236}">
                <a16:creationId xmlns:a16="http://schemas.microsoft.com/office/drawing/2014/main" id="{FF1D39C0-25D0-4F7A-B2C7-6819B551015F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4838" y="1017571"/>
            <a:ext cx="2357934" cy="1761675"/>
          </a:xfrm>
          <a:prstGeom prst="rect">
            <a:avLst/>
          </a:prstGeom>
        </p:spPr>
      </p:pic>
      <p:pic>
        <p:nvPicPr>
          <p:cNvPr id="13" name="Picture 12" descr="A picture containing star, outdoor object, dark, night sky&#10;&#10;Description automatically generated">
            <a:extLst>
              <a:ext uri="{FF2B5EF4-FFF2-40B4-BE49-F238E27FC236}">
                <a16:creationId xmlns:a16="http://schemas.microsoft.com/office/drawing/2014/main" id="{5A60E7BE-ECE7-4346-A5E7-74C26C5E7B63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4838" y="2892987"/>
            <a:ext cx="2357934" cy="176167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11ECB984-8FAA-4682-A1E9-10714641D09C}"/>
              </a:ext>
            </a:extLst>
          </p:cNvPr>
          <p:cNvSpPr txBox="1"/>
          <p:nvPr/>
        </p:nvSpPr>
        <p:spPr>
          <a:xfrm>
            <a:off x="1932923" y="1821237"/>
            <a:ext cx="485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API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34080E8-B565-436B-9AD4-B0EA87A10E0C}"/>
              </a:ext>
            </a:extLst>
          </p:cNvPr>
          <p:cNvSpPr txBox="1"/>
          <p:nvPr/>
        </p:nvSpPr>
        <p:spPr>
          <a:xfrm>
            <a:off x="1408966" y="3634110"/>
            <a:ext cx="1275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G-Alexa-488</a:t>
            </a:r>
          </a:p>
        </p:txBody>
      </p:sp>
      <p:sp>
        <p:nvSpPr>
          <p:cNvPr id="15" name="TextBox 7">
            <a:extLst>
              <a:ext uri="{FF2B5EF4-FFF2-40B4-BE49-F238E27FC236}">
                <a16:creationId xmlns:a16="http://schemas.microsoft.com/office/drawing/2014/main" id="{C8155165-0D39-49F9-9830-8568293A5814}"/>
              </a:ext>
            </a:extLst>
          </p:cNvPr>
          <p:cNvSpPr txBox="1"/>
          <p:nvPr/>
        </p:nvSpPr>
        <p:spPr>
          <a:xfrm>
            <a:off x="3553726" y="512265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7">
            <a:extLst>
              <a:ext uri="{FF2B5EF4-FFF2-40B4-BE49-F238E27FC236}">
                <a16:creationId xmlns:a16="http://schemas.microsoft.com/office/drawing/2014/main" id="{2D52BF69-DE1C-4EFE-8E75-6EE7A9BBB52F}"/>
              </a:ext>
            </a:extLst>
          </p:cNvPr>
          <p:cNvSpPr txBox="1"/>
          <p:nvPr/>
        </p:nvSpPr>
        <p:spPr>
          <a:xfrm>
            <a:off x="5776749" y="521153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7">
            <a:extLst>
              <a:ext uri="{FF2B5EF4-FFF2-40B4-BE49-F238E27FC236}">
                <a16:creationId xmlns:a16="http://schemas.microsoft.com/office/drawing/2014/main" id="{9786806E-ADE1-4706-9C96-86CA2A0BE22A}"/>
              </a:ext>
            </a:extLst>
          </p:cNvPr>
          <p:cNvSpPr txBox="1"/>
          <p:nvPr/>
        </p:nvSpPr>
        <p:spPr>
          <a:xfrm>
            <a:off x="8274183" y="567994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209B291-4467-475B-8204-F387AE92DF03}"/>
              </a:ext>
            </a:extLst>
          </p:cNvPr>
          <p:cNvSpPr/>
          <p:nvPr/>
        </p:nvSpPr>
        <p:spPr>
          <a:xfrm>
            <a:off x="1942067" y="4943886"/>
            <a:ext cx="7883674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3. Internalization of SG in breast cancer cell line. (A)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Probe after fixation. MDA-MB-468 cells seeded on cover slides were fixed with 4% paraformaldehyde, then incubated with SG- Alexa-488 conjugate at 2 µg/ml at room temperature for 2 hours. </a:t>
            </a:r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(B, C) 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Probe before fixation. MDA-MB-468 cells were seeded onto cover slides. SG-Alexa-488 conjugate was added into the culture medium in the wells at 2 µg/ml for 3 and 24 hours. Cells were fixed with 4% paraformaldehyde. The cover slides were mounted onto slide with DAPI counterstaining. Fluorescence on cell surface and in cytoplasm was monitored using fluorescent microscope (40x magnification)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0333079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6FED234A-F0C8-4155-9C62-A564399892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5798298"/>
              </p:ext>
            </p:extLst>
          </p:nvPr>
        </p:nvGraphicFramePr>
        <p:xfrm>
          <a:off x="152531" y="596572"/>
          <a:ext cx="2858335" cy="18870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5" name="SPW 11.0 Graph" r:id="rId3" imgW="5910120" imgH="3845520" progId="SigmaPlotGraphicObject.10">
                  <p:embed/>
                </p:oleObj>
              </mc:Choice>
              <mc:Fallback>
                <p:oleObj name="SPW 11.0 Graph" r:id="rId3" imgW="5910120" imgH="3845520" progId="SigmaPlotGraphicObject.10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6FED234A-F0C8-4155-9C62-A564399892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2531" y="596572"/>
                        <a:ext cx="2858335" cy="18870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B455205-E12C-4B97-B49F-1A48F9A650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7477518"/>
              </p:ext>
            </p:extLst>
          </p:nvPr>
        </p:nvGraphicFramePr>
        <p:xfrm>
          <a:off x="3124728" y="595448"/>
          <a:ext cx="2858335" cy="19353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6" name="SPW 11.0 Graph" r:id="rId5" imgW="5895360" imgH="3933720" progId="SigmaPlotGraphicObject.10">
                  <p:embed/>
                </p:oleObj>
              </mc:Choice>
              <mc:Fallback>
                <p:oleObj name="SPW 11.0 Graph" r:id="rId5" imgW="5895360" imgH="3933720" progId="SigmaPlotGraphicObject.10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B455205-E12C-4B97-B49F-1A48F9A650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124728" y="595448"/>
                        <a:ext cx="2858335" cy="19353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BBD970BA-9D7C-42C1-9DDC-BD32D7EA6BCB}"/>
              </a:ext>
            </a:extLst>
          </p:cNvPr>
          <p:cNvSpPr txBox="1"/>
          <p:nvPr/>
        </p:nvSpPr>
        <p:spPr>
          <a:xfrm>
            <a:off x="4649532" y="1294916"/>
            <a:ext cx="492443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75" b="1" dirty="0"/>
              <a:t>CI: 0.12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8E17AEE-EEE2-42E2-B2C7-B12FCB97F09B}"/>
              </a:ext>
            </a:extLst>
          </p:cNvPr>
          <p:cNvSpPr txBox="1"/>
          <p:nvPr/>
        </p:nvSpPr>
        <p:spPr>
          <a:xfrm>
            <a:off x="1607059" y="1294916"/>
            <a:ext cx="492443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75" b="1" dirty="0"/>
              <a:t>CI: 0.109</a:t>
            </a:r>
          </a:p>
        </p:txBody>
      </p:sp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BA042D86-9CBF-44BE-B22A-BCE341F687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4746749"/>
              </p:ext>
            </p:extLst>
          </p:nvPr>
        </p:nvGraphicFramePr>
        <p:xfrm>
          <a:off x="5933658" y="542524"/>
          <a:ext cx="3065535" cy="20496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7" name="SPW 11.0 Graph" r:id="rId7" imgW="5971320" imgH="3933720" progId="SigmaPlotGraphicObject.10">
                  <p:embed/>
                </p:oleObj>
              </mc:Choice>
              <mc:Fallback>
                <p:oleObj name="SPW 11.0 Graph" r:id="rId7" imgW="5971320" imgH="3933720" progId="SigmaPlotGraphicObject.10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BA042D86-9CBF-44BE-B22A-BCE341F687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933658" y="542524"/>
                        <a:ext cx="3065535" cy="20496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CC8E0B39-72F3-4D0B-98F2-155F62581852}"/>
              </a:ext>
            </a:extLst>
          </p:cNvPr>
          <p:cNvSpPr txBox="1"/>
          <p:nvPr/>
        </p:nvSpPr>
        <p:spPr>
          <a:xfrm>
            <a:off x="7552283" y="1312696"/>
            <a:ext cx="492443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75" b="1" dirty="0"/>
              <a:t>CI: 0.110</a:t>
            </a:r>
          </a:p>
        </p:txBody>
      </p:sp>
      <p:sp>
        <p:nvSpPr>
          <p:cNvPr id="24" name="TextBox 7">
            <a:extLst>
              <a:ext uri="{FF2B5EF4-FFF2-40B4-BE49-F238E27FC236}">
                <a16:creationId xmlns:a16="http://schemas.microsoft.com/office/drawing/2014/main" id="{F2B89DE2-9165-4378-ACB7-62FD617228B2}"/>
              </a:ext>
            </a:extLst>
          </p:cNvPr>
          <p:cNvSpPr txBox="1"/>
          <p:nvPr/>
        </p:nvSpPr>
        <p:spPr>
          <a:xfrm>
            <a:off x="6802734" y="257598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7">
            <a:extLst>
              <a:ext uri="{FF2B5EF4-FFF2-40B4-BE49-F238E27FC236}">
                <a16:creationId xmlns:a16="http://schemas.microsoft.com/office/drawing/2014/main" id="{A3979251-1EFC-4830-9F02-BDFEF1228FB9}"/>
              </a:ext>
            </a:extLst>
          </p:cNvPr>
          <p:cNvSpPr txBox="1"/>
          <p:nvPr/>
        </p:nvSpPr>
        <p:spPr>
          <a:xfrm>
            <a:off x="3817955" y="299614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7">
            <a:extLst>
              <a:ext uri="{FF2B5EF4-FFF2-40B4-BE49-F238E27FC236}">
                <a16:creationId xmlns:a16="http://schemas.microsoft.com/office/drawing/2014/main" id="{5EB8E22B-9A93-47A7-B592-204220CD5158}"/>
              </a:ext>
            </a:extLst>
          </p:cNvPr>
          <p:cNvSpPr txBox="1"/>
          <p:nvPr/>
        </p:nvSpPr>
        <p:spPr>
          <a:xfrm>
            <a:off x="838200" y="379863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TextBox 7">
            <a:extLst>
              <a:ext uri="{FF2B5EF4-FFF2-40B4-BE49-F238E27FC236}">
                <a16:creationId xmlns:a16="http://schemas.microsoft.com/office/drawing/2014/main" id="{01072975-B83F-43E7-A137-BFA6CAFBD673}"/>
              </a:ext>
            </a:extLst>
          </p:cNvPr>
          <p:cNvSpPr txBox="1"/>
          <p:nvPr/>
        </p:nvSpPr>
        <p:spPr>
          <a:xfrm>
            <a:off x="547091" y="2755043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2F16F62-F924-4B7C-9533-E3DFB744F1D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980088" y="207382"/>
            <a:ext cx="3018754" cy="2532045"/>
          </a:xfrm>
          <a:prstGeom prst="rect">
            <a:avLst/>
          </a:prstGeom>
        </p:spPr>
      </p:pic>
      <p:sp>
        <p:nvSpPr>
          <p:cNvPr id="14" name="TextBox 7">
            <a:extLst>
              <a:ext uri="{FF2B5EF4-FFF2-40B4-BE49-F238E27FC236}">
                <a16:creationId xmlns:a16="http://schemas.microsoft.com/office/drawing/2014/main" id="{7911C534-630A-4E3C-91DF-5E51B6F315E2}"/>
              </a:ext>
            </a:extLst>
          </p:cNvPr>
          <p:cNvSpPr txBox="1"/>
          <p:nvPr/>
        </p:nvSpPr>
        <p:spPr>
          <a:xfrm>
            <a:off x="9199218" y="257598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BEB3F2A8-2AE4-4E07-A01D-C8115A4AB96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0002" y="2941823"/>
            <a:ext cx="2767727" cy="2361661"/>
          </a:xfrm>
          <a:prstGeom prst="rect">
            <a:avLst/>
          </a:prstGeom>
        </p:spPr>
      </p:pic>
      <p:pic>
        <p:nvPicPr>
          <p:cNvPr id="21" name="Picture 20" descr="A picture containing logo&#10;&#10;Description automatically generated">
            <a:extLst>
              <a:ext uri="{FF2B5EF4-FFF2-40B4-BE49-F238E27FC236}">
                <a16:creationId xmlns:a16="http://schemas.microsoft.com/office/drawing/2014/main" id="{8E00B2B6-2272-4942-BB5D-AE03FF9E4F2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555" y="2941823"/>
            <a:ext cx="2705447" cy="227073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42D66E3A-E80A-44FA-962C-146352A2E22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8917" y="2882034"/>
            <a:ext cx="2842463" cy="2390310"/>
          </a:xfrm>
          <a:prstGeom prst="rect">
            <a:avLst/>
          </a:prstGeom>
        </p:spPr>
      </p:pic>
      <p:pic>
        <p:nvPicPr>
          <p:cNvPr id="23" name="Picture 22" descr="A picture containing logo&#10;&#10;Description automatically generated">
            <a:extLst>
              <a:ext uri="{FF2B5EF4-FFF2-40B4-BE49-F238E27FC236}">
                <a16:creationId xmlns:a16="http://schemas.microsoft.com/office/drawing/2014/main" id="{7F86351B-33FE-44A3-B670-5EFF1EDCDFB4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569" y="2965152"/>
            <a:ext cx="2661851" cy="2203470"/>
          </a:xfrm>
          <a:prstGeom prst="rect">
            <a:avLst/>
          </a:prstGeom>
        </p:spPr>
      </p:pic>
      <p:sp>
        <p:nvSpPr>
          <p:cNvPr id="27" name="TextBox 7">
            <a:extLst>
              <a:ext uri="{FF2B5EF4-FFF2-40B4-BE49-F238E27FC236}">
                <a16:creationId xmlns:a16="http://schemas.microsoft.com/office/drawing/2014/main" id="{C8076B27-0775-4821-BB60-7D9F2A91E731}"/>
              </a:ext>
            </a:extLst>
          </p:cNvPr>
          <p:cNvSpPr txBox="1"/>
          <p:nvPr/>
        </p:nvSpPr>
        <p:spPr>
          <a:xfrm>
            <a:off x="3519234" y="2715101"/>
            <a:ext cx="26481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8" name="TextBox 7">
            <a:extLst>
              <a:ext uri="{FF2B5EF4-FFF2-40B4-BE49-F238E27FC236}">
                <a16:creationId xmlns:a16="http://schemas.microsoft.com/office/drawing/2014/main" id="{0C250AF7-B094-46D1-A0C5-6C09FD9BB462}"/>
              </a:ext>
            </a:extLst>
          </p:cNvPr>
          <p:cNvSpPr txBox="1"/>
          <p:nvPr/>
        </p:nvSpPr>
        <p:spPr>
          <a:xfrm>
            <a:off x="6286961" y="2715101"/>
            <a:ext cx="28565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9" name="TextBox 7">
            <a:extLst>
              <a:ext uri="{FF2B5EF4-FFF2-40B4-BE49-F238E27FC236}">
                <a16:creationId xmlns:a16="http://schemas.microsoft.com/office/drawing/2014/main" id="{816F1478-A696-400F-927C-EF54284D75A2}"/>
              </a:ext>
            </a:extLst>
          </p:cNvPr>
          <p:cNvSpPr txBox="1"/>
          <p:nvPr/>
        </p:nvSpPr>
        <p:spPr>
          <a:xfrm>
            <a:off x="8989802" y="2817718"/>
            <a:ext cx="27924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9418BBD9-4A38-4CCC-A9A0-4ACB38852D76}"/>
              </a:ext>
            </a:extLst>
          </p:cNvPr>
          <p:cNvSpPr/>
          <p:nvPr/>
        </p:nvSpPr>
        <p:spPr>
          <a:xfrm>
            <a:off x="218645" y="5294815"/>
            <a:ext cx="1178019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4. Decitabine upregulation of TROP2 sensitizes antitumor efficacy of </a:t>
            </a:r>
            <a:r>
              <a:rPr lang="en-US" sz="1400" b="1" dirty="0" err="1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acituzumab</a:t>
            </a:r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400" b="1" dirty="0" err="1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govitecan</a:t>
            </a:r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. (A-C)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IC50 measurement. BCX-010CL, BCX-011CL, and SUM159 cells were treated with decitabine, SG or their combination at concentrations in serial dilutions for 3 days. After viability measurement, dose-response curves of cell inhibition were calculated. IC50s of drugs in single or combination groups and combination index (CI) were calculated using </a:t>
            </a:r>
            <a:r>
              <a:rPr lang="en-US" sz="1400" dirty="0" err="1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CalcuSyn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. (CI&lt;1.0: synergistic; CI=1.0, additive; CI&gt;1.0: antagonistic). </a:t>
            </a:r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(D)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Colony formation assay. Sum159 cells were treated with decitabine, SG and their combinations at the indicated concentrations for 2 weeks. Crystal violet stained cell colonies were imaged. </a:t>
            </a:r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(E-H)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Quantitation of colony areas of cell colonies in Figure 4D, E, F, and L. Total colony areas were measured using ImageJ program. p values were calculated using student’s t-test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7319597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FB64D85-6D55-4416-8B2E-91D469EE94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24000" y="931729"/>
            <a:ext cx="9144000" cy="2653678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A1F0F84E-D593-4E6B-AAE1-C2CD7CA04D37}"/>
              </a:ext>
            </a:extLst>
          </p:cNvPr>
          <p:cNvSpPr/>
          <p:nvPr/>
        </p:nvSpPr>
        <p:spPr>
          <a:xfrm>
            <a:off x="1623221" y="4071001"/>
            <a:ext cx="923985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5. Screening of expression of SLFN11 and TROP2 in cancer cell lines. 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Cell lysates were prepared from cancer cell lines with multiple cancer types. Immunoblotting was performed to detect TROP2 and SLFN11 expression with a normalization of </a:t>
            </a:r>
            <a:r>
              <a:rPr lang="el-GR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β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–actin. </a:t>
            </a:r>
          </a:p>
          <a:p>
            <a:endParaRPr lang="en-US" sz="1400" dirty="0">
              <a:solidFill>
                <a:srgbClr val="0D0D0D"/>
              </a:solidFill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3440005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24EDF78-159D-4AA1-BB33-49A7EED055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0123" y="1167384"/>
            <a:ext cx="5048250" cy="28956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B4BBAD1-D86A-4872-A515-2BE2351EB1E7}"/>
              </a:ext>
            </a:extLst>
          </p:cNvPr>
          <p:cNvSpPr/>
          <p:nvPr/>
        </p:nvSpPr>
        <p:spPr>
          <a:xfrm>
            <a:off x="2244170" y="4400185"/>
            <a:ext cx="923985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6. Effect of combination of decitabine with SN-38 on cell signaling. 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Cells were treated with decitabine at 1 </a:t>
            </a:r>
            <a:r>
              <a:rPr lang="el-GR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μ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M, or SN38 at 5 </a:t>
            </a:r>
            <a:r>
              <a:rPr lang="en-US" sz="1400" dirty="0" err="1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nM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, or combination for 1 and 3 days. Immunoblotting was performed to detect phospho-KAP1, phospho-CHK1, phospho-CHK2, cleaved PARP1, and </a:t>
            </a:r>
            <a:r>
              <a:rPr lang="el-GR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γ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H2AX, with a normalization by </a:t>
            </a:r>
            <a:r>
              <a:rPr lang="el-GR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β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–actin. </a:t>
            </a:r>
          </a:p>
          <a:p>
            <a:endParaRPr lang="en-US" sz="1400" dirty="0">
              <a:solidFill>
                <a:srgbClr val="0D0D0D"/>
              </a:solidFill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7069567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561E570-A689-4BAC-89BB-75DBA43510ED}"/>
              </a:ext>
            </a:extLst>
          </p:cNvPr>
          <p:cNvGrpSpPr/>
          <p:nvPr/>
        </p:nvGrpSpPr>
        <p:grpSpPr>
          <a:xfrm>
            <a:off x="3792007" y="212029"/>
            <a:ext cx="4377572" cy="5137842"/>
            <a:chOff x="3792007" y="1062421"/>
            <a:chExt cx="4377572" cy="513784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627DF93-9A59-41CF-BE06-B80AFFA38F8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76955" y="4832413"/>
              <a:ext cx="2887839" cy="258543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7A5DEF3E-C869-4D17-B97F-2049733A95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76948" y="5658852"/>
              <a:ext cx="2887839" cy="262156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2DD2223-9465-404E-BE72-B27C3FF1FB9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76953" y="2467233"/>
              <a:ext cx="2887839" cy="25239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4FDAC6C-28EE-4358-9C1D-AD8906859BB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76951" y="3219676"/>
              <a:ext cx="2887839" cy="250848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077025F-FF27-4EA0-BBF6-E6D711B1798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376950" y="4008412"/>
              <a:ext cx="2887839" cy="274019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16193C0-F207-46B8-B5A3-167FB6094B1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376951" y="2742430"/>
              <a:ext cx="2887839" cy="226725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8D53E1D-478B-4433-802C-AA833A10E19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376950" y="3508450"/>
              <a:ext cx="2887839" cy="231994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E5F5550-7400-4754-8371-2304AF99FDE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376949" y="4332945"/>
              <a:ext cx="2887839" cy="252288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CDCEA048-A331-44F1-BD20-3A0C2FDFB24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376948" y="5139049"/>
              <a:ext cx="2887839" cy="250358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1DBC1B56-3AB8-4030-8BEA-CFBBF835D0B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376948" y="5975073"/>
              <a:ext cx="2887838" cy="22519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803FAC9-C484-4F92-BD27-A687F4701B58}"/>
                </a:ext>
              </a:extLst>
            </p:cNvPr>
            <p:cNvSpPr txBox="1"/>
            <p:nvPr/>
          </p:nvSpPr>
          <p:spPr>
            <a:xfrm>
              <a:off x="3908977" y="2473624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TOP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B6119A0-D26C-4BF2-96AA-CB6B3B23BD9E}"/>
                </a:ext>
              </a:extLst>
            </p:cNvPr>
            <p:cNvSpPr txBox="1"/>
            <p:nvPr/>
          </p:nvSpPr>
          <p:spPr>
            <a:xfrm>
              <a:off x="3792007" y="2671739"/>
              <a:ext cx="56778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en-US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  <a:endParaRPr lang="en-US" sz="105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48A38C5-F6AC-425E-AEB8-62C6B47ACA29}"/>
                </a:ext>
              </a:extLst>
            </p:cNvPr>
            <p:cNvSpPr txBox="1"/>
            <p:nvPr/>
          </p:nvSpPr>
          <p:spPr>
            <a:xfrm>
              <a:off x="3908977" y="3262243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TOP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D0DC5B3-8ECD-48A4-B4EF-A27E9ACF872D}"/>
                </a:ext>
              </a:extLst>
            </p:cNvPr>
            <p:cNvSpPr txBox="1"/>
            <p:nvPr/>
          </p:nvSpPr>
          <p:spPr>
            <a:xfrm>
              <a:off x="3792007" y="3460358"/>
              <a:ext cx="56778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en-US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  <a:endParaRPr lang="en-US" sz="105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2C6CBEA-AAB2-4660-846E-7EB1C9832975}"/>
                </a:ext>
              </a:extLst>
            </p:cNvPr>
            <p:cNvSpPr txBox="1"/>
            <p:nvPr/>
          </p:nvSpPr>
          <p:spPr>
            <a:xfrm>
              <a:off x="3908977" y="4042034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TOP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AA69F84-C2EB-480C-93BF-C0A869C739F7}"/>
                </a:ext>
              </a:extLst>
            </p:cNvPr>
            <p:cNvSpPr txBox="1"/>
            <p:nvPr/>
          </p:nvSpPr>
          <p:spPr>
            <a:xfrm>
              <a:off x="3792007" y="4240149"/>
              <a:ext cx="56778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en-US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  <a:endParaRPr lang="en-US" sz="105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87C25E6-F773-4F4A-B34E-32CD5FFC89F3}"/>
                </a:ext>
              </a:extLst>
            </p:cNvPr>
            <p:cNvSpPr txBox="1"/>
            <p:nvPr/>
          </p:nvSpPr>
          <p:spPr>
            <a:xfrm>
              <a:off x="3908977" y="4862294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TOP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3909746-588D-4B7A-BB16-E781B706A50C}"/>
                </a:ext>
              </a:extLst>
            </p:cNvPr>
            <p:cNvSpPr txBox="1"/>
            <p:nvPr/>
          </p:nvSpPr>
          <p:spPr>
            <a:xfrm>
              <a:off x="3792007" y="5060410"/>
              <a:ext cx="56778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en-US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  <a:endParaRPr lang="en-US" sz="105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273DADB-2D48-46E0-BD6F-650DAF8AC25A}"/>
                </a:ext>
              </a:extLst>
            </p:cNvPr>
            <p:cNvSpPr txBox="1"/>
            <p:nvPr/>
          </p:nvSpPr>
          <p:spPr>
            <a:xfrm>
              <a:off x="3908977" y="5725448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TOP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800D6CB-1D7C-4A12-BD9E-D4731D5D2B86}"/>
                </a:ext>
              </a:extLst>
            </p:cNvPr>
            <p:cNvSpPr txBox="1"/>
            <p:nvPr/>
          </p:nvSpPr>
          <p:spPr>
            <a:xfrm>
              <a:off x="3792007" y="5923563"/>
              <a:ext cx="56778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en-US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  <a:endParaRPr lang="en-US" sz="105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64A198D-326A-4B7C-AE3F-454A85E2C6DD}"/>
                </a:ext>
              </a:extLst>
            </p:cNvPr>
            <p:cNvSpPr txBox="1"/>
            <p:nvPr/>
          </p:nvSpPr>
          <p:spPr>
            <a:xfrm>
              <a:off x="7264786" y="2588392"/>
              <a:ext cx="77777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BCX-010CL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266FA62-B615-4749-BEFA-DB96EA1F63CE}"/>
                </a:ext>
              </a:extLst>
            </p:cNvPr>
            <p:cNvSpPr txBox="1"/>
            <p:nvPr/>
          </p:nvSpPr>
          <p:spPr>
            <a:xfrm>
              <a:off x="7238144" y="3350181"/>
              <a:ext cx="65594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SUM159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D59CFAF-0C70-408F-BED0-51F108072A32}"/>
                </a:ext>
              </a:extLst>
            </p:cNvPr>
            <p:cNvSpPr txBox="1"/>
            <p:nvPr/>
          </p:nvSpPr>
          <p:spPr>
            <a:xfrm>
              <a:off x="7228296" y="4162233"/>
              <a:ext cx="72968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HCC-1937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436FFE9-800C-4687-9F31-D397DAF80DCC}"/>
                </a:ext>
              </a:extLst>
            </p:cNvPr>
            <p:cNvSpPr txBox="1"/>
            <p:nvPr/>
          </p:nvSpPr>
          <p:spPr>
            <a:xfrm>
              <a:off x="7264786" y="4952403"/>
              <a:ext cx="72968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HCC-114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AB348C6-AEEB-4C73-B00D-C0A205AE1DAB}"/>
                </a:ext>
              </a:extLst>
            </p:cNvPr>
            <p:cNvSpPr txBox="1"/>
            <p:nvPr/>
          </p:nvSpPr>
          <p:spPr>
            <a:xfrm>
              <a:off x="7228296" y="5792326"/>
              <a:ext cx="94128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MDA-MB-157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EF81B87-1098-4E60-BCF5-2CC8C0B84BCD}"/>
                </a:ext>
              </a:extLst>
            </p:cNvPr>
            <p:cNvSpPr txBox="1"/>
            <p:nvPr/>
          </p:nvSpPr>
          <p:spPr>
            <a:xfrm rot="16200000">
              <a:off x="4235924" y="2059916"/>
              <a:ext cx="56938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vehicle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B3B49A9-A35E-48CE-ADDF-FDBCACF40D68}"/>
                </a:ext>
              </a:extLst>
            </p:cNvPr>
            <p:cNvSpPr txBox="1"/>
            <p:nvPr/>
          </p:nvSpPr>
          <p:spPr>
            <a:xfrm rot="16200000">
              <a:off x="6016935" y="1909758"/>
              <a:ext cx="10021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Decitabine (1uM)</a:t>
              </a:r>
            </a:p>
          </p:txBody>
        </p:sp>
        <p:sp>
          <p:nvSpPr>
            <p:cNvPr id="34" name="Isosceles Triangle 33">
              <a:extLst>
                <a:ext uri="{FF2B5EF4-FFF2-40B4-BE49-F238E27FC236}">
                  <a16:creationId xmlns:a16="http://schemas.microsoft.com/office/drawing/2014/main" id="{4F78A97A-854C-4CA5-9A80-9A27557CBAFC}"/>
                </a:ext>
              </a:extLst>
            </p:cNvPr>
            <p:cNvSpPr/>
            <p:nvPr/>
          </p:nvSpPr>
          <p:spPr>
            <a:xfrm rot="16200000">
              <a:off x="5030893" y="1841774"/>
              <a:ext cx="112871" cy="792731"/>
            </a:xfrm>
            <a:prstGeom prst="triangl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/>
            </a:p>
          </p:txBody>
        </p:sp>
        <p:sp>
          <p:nvSpPr>
            <p:cNvPr id="35" name="Isosceles Triangle 34">
              <a:extLst>
                <a:ext uri="{FF2B5EF4-FFF2-40B4-BE49-F238E27FC236}">
                  <a16:creationId xmlns:a16="http://schemas.microsoft.com/office/drawing/2014/main" id="{DB81F8B6-DCEE-41C5-A251-97276225F8B7}"/>
                </a:ext>
              </a:extLst>
            </p:cNvPr>
            <p:cNvSpPr/>
            <p:nvPr/>
          </p:nvSpPr>
          <p:spPr>
            <a:xfrm rot="16200000">
              <a:off x="5881497" y="1842677"/>
              <a:ext cx="112871" cy="792731"/>
            </a:xfrm>
            <a:prstGeom prst="triangl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E7EA50D-4470-4395-961D-0C4102247EC7}"/>
                </a:ext>
              </a:extLst>
            </p:cNvPr>
            <p:cNvSpPr txBox="1"/>
            <p:nvPr/>
          </p:nvSpPr>
          <p:spPr>
            <a:xfrm>
              <a:off x="4769874" y="1944599"/>
              <a:ext cx="15151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SN-38 (nM)              </a:t>
              </a:r>
              <a:r>
                <a:rPr lang="en-US" sz="900" dirty="0" err="1"/>
                <a:t>DXd</a:t>
              </a:r>
              <a:r>
                <a:rPr lang="en-US" sz="900" dirty="0"/>
                <a:t> (nM)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983240C-D20D-4FAE-A203-8F88741B9E6D}"/>
                </a:ext>
              </a:extLst>
            </p:cNvPr>
            <p:cNvSpPr txBox="1"/>
            <p:nvPr/>
          </p:nvSpPr>
          <p:spPr>
            <a:xfrm>
              <a:off x="4677510" y="2280019"/>
              <a:ext cx="17427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10          20    50            5     10    25 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C6AC5B8-A970-4E5E-8984-C4E763E51C5D}"/>
                </a:ext>
              </a:extLst>
            </p:cNvPr>
            <p:cNvSpPr txBox="1"/>
            <p:nvPr/>
          </p:nvSpPr>
          <p:spPr>
            <a:xfrm rot="16200000">
              <a:off x="6056142" y="1682944"/>
              <a:ext cx="14718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Decitabine + SN-38 (10 nM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6BF68DE-94F1-4B63-B8CD-3785BEB4530C}"/>
                </a:ext>
              </a:extLst>
            </p:cNvPr>
            <p:cNvSpPr txBox="1"/>
            <p:nvPr/>
          </p:nvSpPr>
          <p:spPr>
            <a:xfrm rot="16200000">
              <a:off x="6406316" y="1727846"/>
              <a:ext cx="13756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Decitabine + Dxd (10 nM)</a:t>
              </a:r>
            </a:p>
          </p:txBody>
        </p:sp>
      </p:grpSp>
      <p:sp>
        <p:nvSpPr>
          <p:cNvPr id="40" name="Rectangle 39">
            <a:extLst>
              <a:ext uri="{FF2B5EF4-FFF2-40B4-BE49-F238E27FC236}">
                <a16:creationId xmlns:a16="http://schemas.microsoft.com/office/drawing/2014/main" id="{53CBD8BA-6E6E-48A2-9E9F-A5247E74C9D5}"/>
              </a:ext>
            </a:extLst>
          </p:cNvPr>
          <p:cNvSpPr/>
          <p:nvPr/>
        </p:nvSpPr>
        <p:spPr>
          <a:xfrm>
            <a:off x="1476074" y="5555485"/>
            <a:ext cx="923985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7. Effect of payloads on topoisomerase I (TOP1) expression in breast cancer cell lines. 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Five cell lines were treated with SN38, </a:t>
            </a:r>
            <a:r>
              <a:rPr lang="en-US" sz="1400" dirty="0" err="1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DXd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, decitabine, and their combinations at the indicated concentrations for 3 days. Immunoblotting was performed to detect TOP1 expression with a normalization of </a:t>
            </a:r>
            <a:r>
              <a:rPr lang="el-GR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β</a:t>
            </a:r>
            <a:r>
              <a:rPr lang="en-US" sz="1400" dirty="0">
                <a:solidFill>
                  <a:srgbClr val="0D0D0D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–actin. </a:t>
            </a:r>
          </a:p>
        </p:txBody>
      </p:sp>
    </p:spTree>
    <p:extLst>
      <p:ext uri="{BB962C8B-B14F-4D97-AF65-F5344CB8AC3E}">
        <p14:creationId xmlns:p14="http://schemas.microsoft.com/office/powerpoint/2010/main" val="11842271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EFDBA3C-FB50-4EA4-9226-0DF8CEADB44B}"/>
              </a:ext>
            </a:extLst>
          </p:cNvPr>
          <p:cNvSpPr txBox="1"/>
          <p:nvPr/>
        </p:nvSpPr>
        <p:spPr>
          <a:xfrm>
            <a:off x="690888" y="345777"/>
            <a:ext cx="463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cropped and unprocessed blots for </a:t>
            </a:r>
            <a:r>
              <a:rPr lang="en-US" b="1" dirty="0"/>
              <a:t>Figure 2F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6B37E03-D99C-45A2-B2AA-81EAA70224D4}"/>
              </a:ext>
            </a:extLst>
          </p:cNvPr>
          <p:cNvSpPr txBox="1"/>
          <p:nvPr/>
        </p:nvSpPr>
        <p:spPr>
          <a:xfrm>
            <a:off x="5614820" y="2869539"/>
            <a:ext cx="873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ROP2 →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7D4BD4A9-8646-4565-9B95-B68E849472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08846" y="3691151"/>
            <a:ext cx="1083785" cy="155729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F271472C-2755-44DF-8661-897E982555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33572" y="1398636"/>
            <a:ext cx="1041896" cy="85323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2E8D840-18E5-4BC0-B7A7-9FECEFB3BE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26015" y="2307785"/>
            <a:ext cx="1049455" cy="1327453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2C679777-8696-4B36-A44C-F9A44AEDE1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57329" y="5322108"/>
            <a:ext cx="1135302" cy="1430647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E33DD960-090C-430E-B7A7-260FA932DFF0}"/>
              </a:ext>
            </a:extLst>
          </p:cNvPr>
          <p:cNvSpPr txBox="1"/>
          <p:nvPr/>
        </p:nvSpPr>
        <p:spPr>
          <a:xfrm>
            <a:off x="5682018" y="1775692"/>
            <a:ext cx="8066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-Cad →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64ED00A-C049-4D8B-A87B-25CBDBBCC309}"/>
              </a:ext>
            </a:extLst>
          </p:cNvPr>
          <p:cNvSpPr txBox="1"/>
          <p:nvPr/>
        </p:nvSpPr>
        <p:spPr>
          <a:xfrm>
            <a:off x="5509921" y="3963053"/>
            <a:ext cx="923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LFN11 →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5EBAC1B-6BEF-4B49-8876-BD9A720B468C}"/>
              </a:ext>
            </a:extLst>
          </p:cNvPr>
          <p:cNvSpPr txBox="1"/>
          <p:nvPr/>
        </p:nvSpPr>
        <p:spPr>
          <a:xfrm>
            <a:off x="5509921" y="5831604"/>
            <a:ext cx="898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/>
              <a:t>Β</a:t>
            </a:r>
            <a:r>
              <a:rPr lang="en-US" sz="1400" dirty="0"/>
              <a:t>-actin →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663D6B3-BF04-4223-A22F-F94CFE88C14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479124" y="105245"/>
            <a:ext cx="1002573" cy="1219728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77940B3F-2659-4BCF-B1E6-1DE5A64C66E4}"/>
              </a:ext>
            </a:extLst>
          </p:cNvPr>
          <p:cNvSpPr txBox="1"/>
          <p:nvPr/>
        </p:nvSpPr>
        <p:spPr>
          <a:xfrm>
            <a:off x="5782378" y="332280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ZEB1 →</a:t>
            </a:r>
          </a:p>
        </p:txBody>
      </p:sp>
    </p:spTree>
    <p:extLst>
      <p:ext uri="{BB962C8B-B14F-4D97-AF65-F5344CB8AC3E}">
        <p14:creationId xmlns:p14="http://schemas.microsoft.com/office/powerpoint/2010/main" val="1433194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D081E65E-CDC3-4502-B62A-5D4463D544EA}"/>
              </a:ext>
            </a:extLst>
          </p:cNvPr>
          <p:cNvGrpSpPr/>
          <p:nvPr/>
        </p:nvGrpSpPr>
        <p:grpSpPr>
          <a:xfrm>
            <a:off x="1896351" y="1100763"/>
            <a:ext cx="7732088" cy="4800085"/>
            <a:chOff x="2108211" y="624513"/>
            <a:chExt cx="7732088" cy="4800085"/>
          </a:xfrm>
        </p:grpSpPr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D94E8861-16EE-4ADD-A6B1-81B76FD05DF6}"/>
                </a:ext>
              </a:extLst>
            </p:cNvPr>
            <p:cNvGrpSpPr/>
            <p:nvPr/>
          </p:nvGrpSpPr>
          <p:grpSpPr>
            <a:xfrm>
              <a:off x="2910308" y="1606726"/>
              <a:ext cx="6914152" cy="3379840"/>
              <a:chOff x="5622304" y="905081"/>
              <a:chExt cx="5848122" cy="2726274"/>
            </a:xfrm>
          </p:grpSpPr>
          <p:pic>
            <p:nvPicPr>
              <p:cNvPr id="73" name="Picture 72">
                <a:extLst>
                  <a:ext uri="{FF2B5EF4-FFF2-40B4-BE49-F238E27FC236}">
                    <a16:creationId xmlns:a16="http://schemas.microsoft.com/office/drawing/2014/main" id="{C06566C1-50F0-4F78-8935-1B96187249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640592" y="915740"/>
                <a:ext cx="2907798" cy="697993"/>
              </a:xfrm>
              <a:prstGeom prst="rect">
                <a:avLst/>
              </a:prstGeom>
            </p:spPr>
          </p:pic>
          <p:pic>
            <p:nvPicPr>
              <p:cNvPr id="74" name="Picture 73">
                <a:extLst>
                  <a:ext uri="{FF2B5EF4-FFF2-40B4-BE49-F238E27FC236}">
                    <a16:creationId xmlns:a16="http://schemas.microsoft.com/office/drawing/2014/main" id="{0409A4F6-F5D2-47ED-9704-7DB726D511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622304" y="1691408"/>
                <a:ext cx="2926086" cy="1002794"/>
              </a:xfrm>
              <a:prstGeom prst="rect">
                <a:avLst/>
              </a:prstGeom>
            </p:spPr>
          </p:pic>
          <p:pic>
            <p:nvPicPr>
              <p:cNvPr id="75" name="Picture 74">
                <a:extLst>
                  <a:ext uri="{FF2B5EF4-FFF2-40B4-BE49-F238E27FC236}">
                    <a16:creationId xmlns:a16="http://schemas.microsoft.com/office/drawing/2014/main" id="{DF7E7B51-E278-4907-AB50-E7AF598F4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659800" y="905081"/>
                <a:ext cx="2804166" cy="710185"/>
              </a:xfrm>
              <a:prstGeom prst="rect">
                <a:avLst/>
              </a:prstGeom>
            </p:spPr>
          </p:pic>
          <p:pic>
            <p:nvPicPr>
              <p:cNvPr id="76" name="Picture 75">
                <a:extLst>
                  <a:ext uri="{FF2B5EF4-FFF2-40B4-BE49-F238E27FC236}">
                    <a16:creationId xmlns:a16="http://schemas.microsoft.com/office/drawing/2014/main" id="{34E21D43-0F3D-4395-B724-25E26BAF21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674191" y="1691408"/>
                <a:ext cx="2791974" cy="917450"/>
              </a:xfrm>
              <a:prstGeom prst="rect">
                <a:avLst/>
              </a:prstGeom>
            </p:spPr>
          </p:pic>
          <p:pic>
            <p:nvPicPr>
              <p:cNvPr id="78" name="Picture 77">
                <a:extLst>
                  <a:ext uri="{FF2B5EF4-FFF2-40B4-BE49-F238E27FC236}">
                    <a16:creationId xmlns:a16="http://schemas.microsoft.com/office/drawing/2014/main" id="{DD72A84F-E724-4C9C-B0B6-F9450B8D8A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639926" y="2738289"/>
                <a:ext cx="2919990" cy="893066"/>
              </a:xfrm>
              <a:prstGeom prst="rect">
                <a:avLst/>
              </a:prstGeom>
            </p:spPr>
          </p:pic>
          <p:pic>
            <p:nvPicPr>
              <p:cNvPr id="79" name="Picture 78">
                <a:extLst>
                  <a:ext uri="{FF2B5EF4-FFF2-40B4-BE49-F238E27FC236}">
                    <a16:creationId xmlns:a16="http://schemas.microsoft.com/office/drawing/2014/main" id="{9D3E5972-97E7-4DFE-AC8E-9D52342F04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675404" y="2720545"/>
                <a:ext cx="2795022" cy="908306"/>
              </a:xfrm>
              <a:prstGeom prst="rect">
                <a:avLst/>
              </a:prstGeom>
            </p:spPr>
          </p:pic>
        </p:grp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8600DCDF-4773-4698-B051-C79E5F355E69}"/>
                </a:ext>
              </a:extLst>
            </p:cNvPr>
            <p:cNvCxnSpPr/>
            <p:nvPr/>
          </p:nvCxnSpPr>
          <p:spPr>
            <a:xfrm>
              <a:off x="4704898" y="1490552"/>
              <a:ext cx="0" cy="39340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651AE2E9-D694-4725-86B8-ADC8DF2278FA}"/>
                </a:ext>
              </a:extLst>
            </p:cNvPr>
            <p:cNvCxnSpPr>
              <a:cxnSpLocks/>
            </p:cNvCxnSpPr>
            <p:nvPr/>
          </p:nvCxnSpPr>
          <p:spPr>
            <a:xfrm>
              <a:off x="8382215" y="624513"/>
              <a:ext cx="0" cy="445688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D5DB7AB2-57D6-4052-81E9-5A07E46F7900}"/>
                </a:ext>
              </a:extLst>
            </p:cNvPr>
            <p:cNvSpPr txBox="1"/>
            <p:nvPr/>
          </p:nvSpPr>
          <p:spPr>
            <a:xfrm>
              <a:off x="3531035" y="1383607"/>
              <a:ext cx="49888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BCX-010CL                    BCX-011CL                                 SUM159            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049706E7-3314-415C-AE70-A181ED8A6148}"/>
                </a:ext>
              </a:extLst>
            </p:cNvPr>
            <p:cNvSpPr txBox="1"/>
            <p:nvPr/>
          </p:nvSpPr>
          <p:spPr>
            <a:xfrm>
              <a:off x="2189085" y="1793519"/>
              <a:ext cx="8066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E-Cad →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21694264-3CC0-4B52-B9B0-45F721AA3252}"/>
                </a:ext>
              </a:extLst>
            </p:cNvPr>
            <p:cNvSpPr txBox="1"/>
            <p:nvPr/>
          </p:nvSpPr>
          <p:spPr>
            <a:xfrm>
              <a:off x="2120299" y="2897213"/>
              <a:ext cx="873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TROP2 →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C1C68427-5A95-48E5-9BAD-B8DBFD713CCD}"/>
                </a:ext>
              </a:extLst>
            </p:cNvPr>
            <p:cNvSpPr txBox="1"/>
            <p:nvPr/>
          </p:nvSpPr>
          <p:spPr>
            <a:xfrm>
              <a:off x="2108211" y="4151123"/>
              <a:ext cx="8980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/>
                <a:t>Β</a:t>
              </a:r>
              <a:r>
                <a:rPr lang="en-US" sz="1400" dirty="0"/>
                <a:t>-actin →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6CD27BDC-182A-46BA-AA7F-D89050238385}"/>
                </a:ext>
              </a:extLst>
            </p:cNvPr>
            <p:cNvCxnSpPr>
              <a:cxnSpLocks/>
            </p:cNvCxnSpPr>
            <p:nvPr/>
          </p:nvCxnSpPr>
          <p:spPr>
            <a:xfrm>
              <a:off x="3133940" y="704683"/>
              <a:ext cx="0" cy="445688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B2C9B27-F28D-4D96-8345-8D63D5CFC315}"/>
                </a:ext>
              </a:extLst>
            </p:cNvPr>
            <p:cNvSpPr txBox="1"/>
            <p:nvPr/>
          </p:nvSpPr>
          <p:spPr>
            <a:xfrm>
              <a:off x="4862013" y="883868"/>
              <a:ext cx="49782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Figure 3A samples</a:t>
              </a:r>
              <a:r>
                <a:rPr lang="en-US" dirty="0"/>
                <a:t>                                   </a:t>
              </a:r>
              <a:r>
                <a:rPr lang="en-US" sz="1600" dirty="0"/>
                <a:t>Other samples</a:t>
              </a:r>
              <a:endParaRPr lang="en-US" dirty="0"/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621C9C26-7C95-4143-A69E-CE862DE8ED31}"/>
              </a:ext>
            </a:extLst>
          </p:cNvPr>
          <p:cNvSpPr txBox="1"/>
          <p:nvPr/>
        </p:nvSpPr>
        <p:spPr>
          <a:xfrm>
            <a:off x="3319175" y="318793"/>
            <a:ext cx="463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cropped and unprocessed blots for </a:t>
            </a:r>
            <a:r>
              <a:rPr lang="en-US" b="1" dirty="0"/>
              <a:t>Figure 3A</a:t>
            </a:r>
          </a:p>
        </p:txBody>
      </p:sp>
    </p:spTree>
    <p:extLst>
      <p:ext uri="{BB962C8B-B14F-4D97-AF65-F5344CB8AC3E}">
        <p14:creationId xmlns:p14="http://schemas.microsoft.com/office/powerpoint/2010/main" val="2324645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27</TotalTime>
  <Words>1064</Words>
  <Application>Microsoft Office PowerPoint</Application>
  <PresentationFormat>Widescreen</PresentationFormat>
  <Paragraphs>158</Paragraphs>
  <Slides>1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2" baseType="lpstr">
      <vt:lpstr>Arial</vt:lpstr>
      <vt:lpstr>Calibri</vt:lpstr>
      <vt:lpstr>Calibri Light</vt:lpstr>
      <vt:lpstr>Courier New</vt:lpstr>
      <vt:lpstr>Times New Roman</vt:lpstr>
      <vt:lpstr>Office Theme</vt:lpstr>
      <vt:lpstr>SPW 11.0 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o,Ming</dc:creator>
  <cp:lastModifiedBy>Zhao,Ming</cp:lastModifiedBy>
  <cp:revision>51</cp:revision>
  <dcterms:created xsi:type="dcterms:W3CDTF">2022-06-04T19:00:55Z</dcterms:created>
  <dcterms:modified xsi:type="dcterms:W3CDTF">2023-06-22T14:50:30Z</dcterms:modified>
</cp:coreProperties>
</file>